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65472C0-0AD8-4F9D-9100-4602D5E3EE92}" v="26" dt="2023-04-04T09:18:26.36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1236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濵田　大治" userId="3dc346c6-a235-4d96-b756-7f3e038a9511" providerId="ADAL" clId="{F07BBF69-9FD5-4B0C-BEED-CD5FC0D3B778}"/>
    <pc:docChg chg="undo custSel addSld modSld">
      <pc:chgData name="濵田　大治" userId="3dc346c6-a235-4d96-b756-7f3e038a9511" providerId="ADAL" clId="{F07BBF69-9FD5-4B0C-BEED-CD5FC0D3B778}" dt="2023-01-31T05:10:16.945" v="116" actId="1076"/>
      <pc:docMkLst>
        <pc:docMk/>
      </pc:docMkLst>
      <pc:sldChg chg="addSp delSp modSp add mod">
        <pc:chgData name="濵田　大治" userId="3dc346c6-a235-4d96-b756-7f3e038a9511" providerId="ADAL" clId="{F07BBF69-9FD5-4B0C-BEED-CD5FC0D3B778}" dt="2023-01-31T05:04:44.245" v="62" actId="1076"/>
        <pc:sldMkLst>
          <pc:docMk/>
          <pc:sldMk cId="1105138256" sldId="259"/>
        </pc:sldMkLst>
        <pc:spChg chg="add mod">
          <ac:chgData name="濵田　大治" userId="3dc346c6-a235-4d96-b756-7f3e038a9511" providerId="ADAL" clId="{F07BBF69-9FD5-4B0C-BEED-CD5FC0D3B778}" dt="2023-01-31T05:03:21.227" v="47" actId="14100"/>
          <ac:spMkLst>
            <pc:docMk/>
            <pc:sldMk cId="1105138256" sldId="259"/>
            <ac:spMk id="3" creationId="{5E4A5850-5FB8-976F-2978-B81D21F57590}"/>
          </ac:spMkLst>
        </pc:spChg>
        <pc:spChg chg="add mod">
          <ac:chgData name="濵田　大治" userId="3dc346c6-a235-4d96-b756-7f3e038a9511" providerId="ADAL" clId="{F07BBF69-9FD5-4B0C-BEED-CD5FC0D3B778}" dt="2023-01-31T05:04:44.245" v="62" actId="1076"/>
          <ac:spMkLst>
            <pc:docMk/>
            <pc:sldMk cId="1105138256" sldId="259"/>
            <ac:spMk id="5" creationId="{AC04AF93-84B7-9D73-6456-9C61CAA2754D}"/>
          </ac:spMkLst>
        </pc:spChg>
        <pc:spChg chg="mod">
          <ac:chgData name="濵田　大治" userId="3dc346c6-a235-4d96-b756-7f3e038a9511" providerId="ADAL" clId="{F07BBF69-9FD5-4B0C-BEED-CD5FC0D3B778}" dt="2023-01-31T04:53:56.332" v="7" actId="20577"/>
          <ac:spMkLst>
            <pc:docMk/>
            <pc:sldMk cId="1105138256" sldId="259"/>
            <ac:spMk id="6" creationId="{29E893D0-3FCA-97F7-A79B-508862C96441}"/>
          </ac:spMkLst>
        </pc:spChg>
        <pc:spChg chg="mod">
          <ac:chgData name="濵田　大治" userId="3dc346c6-a235-4d96-b756-7f3e038a9511" providerId="ADAL" clId="{F07BBF69-9FD5-4B0C-BEED-CD5FC0D3B778}" dt="2023-01-31T04:53:43.921" v="6" actId="20577"/>
          <ac:spMkLst>
            <pc:docMk/>
            <pc:sldMk cId="1105138256" sldId="259"/>
            <ac:spMk id="8" creationId="{72C1DD76-8AA7-C565-242E-80107ED73F08}"/>
          </ac:spMkLst>
        </pc:spChg>
        <pc:spChg chg="del">
          <ac:chgData name="濵田　大治" userId="3dc346c6-a235-4d96-b756-7f3e038a9511" providerId="ADAL" clId="{F07BBF69-9FD5-4B0C-BEED-CD5FC0D3B778}" dt="2023-01-31T04:59:04.126" v="9" actId="478"/>
          <ac:spMkLst>
            <pc:docMk/>
            <pc:sldMk cId="1105138256" sldId="259"/>
            <ac:spMk id="11" creationId="{E6EF5794-ACD2-1C54-4CDC-2C60CAA6E053}"/>
          </ac:spMkLst>
        </pc:spChg>
        <pc:spChg chg="del">
          <ac:chgData name="濵田　大治" userId="3dc346c6-a235-4d96-b756-7f3e038a9511" providerId="ADAL" clId="{F07BBF69-9FD5-4B0C-BEED-CD5FC0D3B778}" dt="2023-01-31T04:59:01.353" v="8" actId="478"/>
          <ac:spMkLst>
            <pc:docMk/>
            <pc:sldMk cId="1105138256" sldId="259"/>
            <ac:spMk id="12" creationId="{F2904211-4805-885F-5465-CC578AFAF2A2}"/>
          </ac:spMkLst>
        </pc:spChg>
        <pc:spChg chg="mod">
          <ac:chgData name="濵田　大治" userId="3dc346c6-a235-4d96-b756-7f3e038a9511" providerId="ADAL" clId="{F07BBF69-9FD5-4B0C-BEED-CD5FC0D3B778}" dt="2023-01-31T05:00:08.474" v="25" actId="1036"/>
          <ac:spMkLst>
            <pc:docMk/>
            <pc:sldMk cId="1105138256" sldId="259"/>
            <ac:spMk id="13" creationId="{BA0ABD70-22B5-B75E-D56B-B690BF4721B0}"/>
          </ac:spMkLst>
        </pc:spChg>
        <pc:spChg chg="mod">
          <ac:chgData name="濵田　大治" userId="3dc346c6-a235-4d96-b756-7f3e038a9511" providerId="ADAL" clId="{F07BBF69-9FD5-4B0C-BEED-CD5FC0D3B778}" dt="2023-01-31T05:00:08.474" v="25" actId="1036"/>
          <ac:spMkLst>
            <pc:docMk/>
            <pc:sldMk cId="1105138256" sldId="259"/>
            <ac:spMk id="14" creationId="{4A9A80DD-9095-7AA4-9E18-B1D95432DA60}"/>
          </ac:spMkLst>
        </pc:spChg>
        <pc:spChg chg="mod">
          <ac:chgData name="濵田　大治" userId="3dc346c6-a235-4d96-b756-7f3e038a9511" providerId="ADAL" clId="{F07BBF69-9FD5-4B0C-BEED-CD5FC0D3B778}" dt="2023-01-31T05:00:08.474" v="25" actId="1036"/>
          <ac:spMkLst>
            <pc:docMk/>
            <pc:sldMk cId="1105138256" sldId="259"/>
            <ac:spMk id="15" creationId="{E9D7AD65-5FFD-25F0-19E5-82AF3EC11446}"/>
          </ac:spMkLst>
        </pc:spChg>
        <pc:spChg chg="mod">
          <ac:chgData name="濵田　大治" userId="3dc346c6-a235-4d96-b756-7f3e038a9511" providerId="ADAL" clId="{F07BBF69-9FD5-4B0C-BEED-CD5FC0D3B778}" dt="2023-01-31T05:01:07.814" v="35" actId="1035"/>
          <ac:spMkLst>
            <pc:docMk/>
            <pc:sldMk cId="1105138256" sldId="259"/>
            <ac:spMk id="16" creationId="{2C205221-A575-4568-653F-0D3E16861442}"/>
          </ac:spMkLst>
        </pc:spChg>
        <pc:spChg chg="add mod">
          <ac:chgData name="濵田　大治" userId="3dc346c6-a235-4d96-b756-7f3e038a9511" providerId="ADAL" clId="{F07BBF69-9FD5-4B0C-BEED-CD5FC0D3B778}" dt="2023-01-31T05:00:55.188" v="29" actId="14100"/>
          <ac:spMkLst>
            <pc:docMk/>
            <pc:sldMk cId="1105138256" sldId="259"/>
            <ac:spMk id="17" creationId="{B4FBE997-F336-A1C5-AA12-735F9BF4D912}"/>
          </ac:spMkLst>
        </pc:spChg>
        <pc:spChg chg="add mod">
          <ac:chgData name="濵田　大治" userId="3dc346c6-a235-4d96-b756-7f3e038a9511" providerId="ADAL" clId="{F07BBF69-9FD5-4B0C-BEED-CD5FC0D3B778}" dt="2023-01-31T04:59:46.121" v="14" actId="14100"/>
          <ac:spMkLst>
            <pc:docMk/>
            <pc:sldMk cId="1105138256" sldId="259"/>
            <ac:spMk id="20" creationId="{4A5B56C5-2831-F674-6EE3-8029B573544C}"/>
          </ac:spMkLst>
        </pc:spChg>
        <pc:spChg chg="add mod">
          <ac:chgData name="濵田　大治" userId="3dc346c6-a235-4d96-b756-7f3e038a9511" providerId="ADAL" clId="{F07BBF69-9FD5-4B0C-BEED-CD5FC0D3B778}" dt="2023-01-31T05:01:45.806" v="38" actId="1076"/>
          <ac:spMkLst>
            <pc:docMk/>
            <pc:sldMk cId="1105138256" sldId="259"/>
            <ac:spMk id="21" creationId="{4C622EB2-32BD-3C12-27B5-FE55471910AF}"/>
          </ac:spMkLst>
        </pc:spChg>
        <pc:spChg chg="add mod">
          <ac:chgData name="濵田　大治" userId="3dc346c6-a235-4d96-b756-7f3e038a9511" providerId="ADAL" clId="{F07BBF69-9FD5-4B0C-BEED-CD5FC0D3B778}" dt="2023-01-31T05:01:45.806" v="38" actId="1076"/>
          <ac:spMkLst>
            <pc:docMk/>
            <pc:sldMk cId="1105138256" sldId="259"/>
            <ac:spMk id="22" creationId="{2CCD35AA-7E5B-2D32-DFE5-1DC139F2DE18}"/>
          </ac:spMkLst>
        </pc:spChg>
        <pc:spChg chg="add mod">
          <ac:chgData name="濵田　大治" userId="3dc346c6-a235-4d96-b756-7f3e038a9511" providerId="ADAL" clId="{F07BBF69-9FD5-4B0C-BEED-CD5FC0D3B778}" dt="2023-01-31T05:01:45.806" v="38" actId="1076"/>
          <ac:spMkLst>
            <pc:docMk/>
            <pc:sldMk cId="1105138256" sldId="259"/>
            <ac:spMk id="23" creationId="{ED2E5685-7346-5FDF-20E4-BB86F28FA964}"/>
          </ac:spMkLst>
        </pc:spChg>
        <pc:spChg chg="add mod">
          <ac:chgData name="濵田　大治" userId="3dc346c6-a235-4d96-b756-7f3e038a9511" providerId="ADAL" clId="{F07BBF69-9FD5-4B0C-BEED-CD5FC0D3B778}" dt="2023-01-31T05:01:45.806" v="38" actId="1076"/>
          <ac:spMkLst>
            <pc:docMk/>
            <pc:sldMk cId="1105138256" sldId="259"/>
            <ac:spMk id="24" creationId="{C0646EA5-E18F-4ECE-8BFE-A95BF6304D6B}"/>
          </ac:spMkLst>
        </pc:spChg>
        <pc:spChg chg="add mod">
          <ac:chgData name="濵田　大治" userId="3dc346c6-a235-4d96-b756-7f3e038a9511" providerId="ADAL" clId="{F07BBF69-9FD5-4B0C-BEED-CD5FC0D3B778}" dt="2023-01-31T05:01:45.806" v="38" actId="1076"/>
          <ac:spMkLst>
            <pc:docMk/>
            <pc:sldMk cId="1105138256" sldId="259"/>
            <ac:spMk id="25" creationId="{8BCFAE96-486B-E68B-3933-B7146BCDC7A4}"/>
          </ac:spMkLst>
        </pc:spChg>
        <pc:spChg chg="add mod">
          <ac:chgData name="濵田　大治" userId="3dc346c6-a235-4d96-b756-7f3e038a9511" providerId="ADAL" clId="{F07BBF69-9FD5-4B0C-BEED-CD5FC0D3B778}" dt="2023-01-31T05:01:45.806" v="38" actId="1076"/>
          <ac:spMkLst>
            <pc:docMk/>
            <pc:sldMk cId="1105138256" sldId="259"/>
            <ac:spMk id="26" creationId="{AEEB2E70-8C1E-CD9A-709B-A691F879C64E}"/>
          </ac:spMkLst>
        </pc:spChg>
        <pc:picChg chg="add del mod modCrop">
          <ac:chgData name="濵田　大治" userId="3dc346c6-a235-4d96-b756-7f3e038a9511" providerId="ADAL" clId="{F07BBF69-9FD5-4B0C-BEED-CD5FC0D3B778}" dt="2023-01-31T05:03:23.868" v="48" actId="478"/>
          <ac:picMkLst>
            <pc:docMk/>
            <pc:sldMk cId="1105138256" sldId="259"/>
            <ac:picMk id="2" creationId="{63D5613C-FE5A-0EBB-E952-0856696B617D}"/>
          </ac:picMkLst>
        </pc:picChg>
        <pc:picChg chg="add del mod modCrop">
          <ac:chgData name="濵田　大治" userId="3dc346c6-a235-4d96-b756-7f3e038a9511" providerId="ADAL" clId="{F07BBF69-9FD5-4B0C-BEED-CD5FC0D3B778}" dt="2023-01-31T05:04:29.002" v="61" actId="478"/>
          <ac:picMkLst>
            <pc:docMk/>
            <pc:sldMk cId="1105138256" sldId="259"/>
            <ac:picMk id="4" creationId="{AFE454FF-9DC7-F7EE-5003-87170B6CC2E4}"/>
          </ac:picMkLst>
        </pc:picChg>
        <pc:picChg chg="del">
          <ac:chgData name="濵田　大治" userId="3dc346c6-a235-4d96-b756-7f3e038a9511" providerId="ADAL" clId="{F07BBF69-9FD5-4B0C-BEED-CD5FC0D3B778}" dt="2023-01-31T04:59:04.126" v="9" actId="478"/>
          <ac:picMkLst>
            <pc:docMk/>
            <pc:sldMk cId="1105138256" sldId="259"/>
            <ac:picMk id="9" creationId="{5D95017C-55CF-21CD-85F3-6E6E9865B026}"/>
          </ac:picMkLst>
        </pc:picChg>
        <pc:picChg chg="add mod ord">
          <ac:chgData name="濵田　大治" userId="3dc346c6-a235-4d96-b756-7f3e038a9511" providerId="ADAL" clId="{F07BBF69-9FD5-4B0C-BEED-CD5FC0D3B778}" dt="2023-01-31T05:01:11.998" v="36" actId="167"/>
          <ac:picMkLst>
            <pc:docMk/>
            <pc:sldMk cId="1105138256" sldId="259"/>
            <ac:picMk id="10" creationId="{E6F5ACB3-6431-C040-4BE0-5BF84A69A617}"/>
          </ac:picMkLst>
        </pc:picChg>
        <pc:picChg chg="del">
          <ac:chgData name="濵田　大治" userId="3dc346c6-a235-4d96-b756-7f3e038a9511" providerId="ADAL" clId="{F07BBF69-9FD5-4B0C-BEED-CD5FC0D3B778}" dt="2023-01-31T04:59:01.353" v="8" actId="478"/>
          <ac:picMkLst>
            <pc:docMk/>
            <pc:sldMk cId="1105138256" sldId="259"/>
            <ac:picMk id="18" creationId="{62FFA1C6-6811-1BEF-971E-5FB7A0E3162C}"/>
          </ac:picMkLst>
        </pc:picChg>
        <pc:picChg chg="add mod ord">
          <ac:chgData name="濵田　大治" userId="3dc346c6-a235-4d96-b756-7f3e038a9511" providerId="ADAL" clId="{F07BBF69-9FD5-4B0C-BEED-CD5FC0D3B778}" dt="2023-01-31T04:59:35.940" v="13" actId="167"/>
          <ac:picMkLst>
            <pc:docMk/>
            <pc:sldMk cId="1105138256" sldId="259"/>
            <ac:picMk id="19" creationId="{FB6A593D-5E4D-B8F2-4DDA-E91B3456C14D}"/>
          </ac:picMkLst>
        </pc:picChg>
        <pc:picChg chg="add mod ord">
          <ac:chgData name="濵田　大治" userId="3dc346c6-a235-4d96-b756-7f3e038a9511" providerId="ADAL" clId="{F07BBF69-9FD5-4B0C-BEED-CD5FC0D3B778}" dt="2023-01-31T05:03:02.590" v="45" actId="167"/>
          <ac:picMkLst>
            <pc:docMk/>
            <pc:sldMk cId="1105138256" sldId="259"/>
            <ac:picMk id="27" creationId="{822D2D39-E451-1833-BAC0-89C3D26C890E}"/>
          </ac:picMkLst>
        </pc:picChg>
        <pc:picChg chg="add mod ord">
          <ac:chgData name="濵田　大治" userId="3dc346c6-a235-4d96-b756-7f3e038a9511" providerId="ADAL" clId="{F07BBF69-9FD5-4B0C-BEED-CD5FC0D3B778}" dt="2023-01-31T05:04:15.781" v="58" actId="167"/>
          <ac:picMkLst>
            <pc:docMk/>
            <pc:sldMk cId="1105138256" sldId="259"/>
            <ac:picMk id="28" creationId="{28452614-43A4-00E3-5CC8-0F1A183866F1}"/>
          </ac:picMkLst>
        </pc:picChg>
      </pc:sldChg>
      <pc:sldChg chg="addSp delSp modSp add mod">
        <pc:chgData name="濵田　大治" userId="3dc346c6-a235-4d96-b756-7f3e038a9511" providerId="ADAL" clId="{F07BBF69-9FD5-4B0C-BEED-CD5FC0D3B778}" dt="2023-01-31T05:10:16.945" v="116" actId="1076"/>
        <pc:sldMkLst>
          <pc:docMk/>
          <pc:sldMk cId="3665629369" sldId="260"/>
        </pc:sldMkLst>
        <pc:spChg chg="del">
          <ac:chgData name="濵田　大治" userId="3dc346c6-a235-4d96-b756-7f3e038a9511" providerId="ADAL" clId="{F07BBF69-9FD5-4B0C-BEED-CD5FC0D3B778}" dt="2023-01-31T05:06:02.687" v="66" actId="478"/>
          <ac:spMkLst>
            <pc:docMk/>
            <pc:sldMk cId="3665629369" sldId="260"/>
            <ac:spMk id="3" creationId="{5E4A5850-5FB8-976F-2978-B81D21F57590}"/>
          </ac:spMkLst>
        </pc:spChg>
        <pc:spChg chg="del">
          <ac:chgData name="濵田　大治" userId="3dc346c6-a235-4d96-b756-7f3e038a9511" providerId="ADAL" clId="{F07BBF69-9FD5-4B0C-BEED-CD5FC0D3B778}" dt="2023-01-31T05:06:02.687" v="66" actId="478"/>
          <ac:spMkLst>
            <pc:docMk/>
            <pc:sldMk cId="3665629369" sldId="260"/>
            <ac:spMk id="5" creationId="{AC04AF93-84B7-9D73-6456-9C61CAA2754D}"/>
          </ac:spMkLst>
        </pc:spChg>
        <pc:spChg chg="mod">
          <ac:chgData name="濵田　大治" userId="3dc346c6-a235-4d96-b756-7f3e038a9511" providerId="ADAL" clId="{F07BBF69-9FD5-4B0C-BEED-CD5FC0D3B778}" dt="2023-01-31T05:05:13.826" v="65" actId="20577"/>
          <ac:spMkLst>
            <pc:docMk/>
            <pc:sldMk cId="3665629369" sldId="260"/>
            <ac:spMk id="6" creationId="{29E893D0-3FCA-97F7-A79B-508862C96441}"/>
          </ac:spMkLst>
        </pc:spChg>
        <pc:spChg chg="mod">
          <ac:chgData name="濵田　大治" userId="3dc346c6-a235-4d96-b756-7f3e038a9511" providerId="ADAL" clId="{F07BBF69-9FD5-4B0C-BEED-CD5FC0D3B778}" dt="2023-01-31T05:07:26.877" v="84" actId="20577"/>
          <ac:spMkLst>
            <pc:docMk/>
            <pc:sldMk cId="3665629369" sldId="260"/>
            <ac:spMk id="7" creationId="{50FEC825-AE2B-9FF0-CDEF-B99EA12E07A3}"/>
          </ac:spMkLst>
        </pc:spChg>
        <pc:spChg chg="mod">
          <ac:chgData name="濵田　大治" userId="3dc346c6-a235-4d96-b756-7f3e038a9511" providerId="ADAL" clId="{F07BBF69-9FD5-4B0C-BEED-CD5FC0D3B778}" dt="2023-01-31T05:08:41.490" v="97" actId="1076"/>
          <ac:spMkLst>
            <pc:docMk/>
            <pc:sldMk cId="3665629369" sldId="260"/>
            <ac:spMk id="8" creationId="{72C1DD76-8AA7-C565-242E-80107ED73F08}"/>
          </ac:spMkLst>
        </pc:spChg>
        <pc:spChg chg="add mod">
          <ac:chgData name="濵田　大治" userId="3dc346c6-a235-4d96-b756-7f3e038a9511" providerId="ADAL" clId="{F07BBF69-9FD5-4B0C-BEED-CD5FC0D3B778}" dt="2023-01-31T05:09:38.080" v="109" actId="1076"/>
          <ac:spMkLst>
            <pc:docMk/>
            <pc:sldMk cId="3665629369" sldId="260"/>
            <ac:spMk id="9" creationId="{6931CF5D-B3F5-33DB-B16F-3BC0CB5577B0}"/>
          </ac:spMkLst>
        </pc:spChg>
        <pc:spChg chg="add mod">
          <ac:chgData name="濵田　大治" userId="3dc346c6-a235-4d96-b756-7f3e038a9511" providerId="ADAL" clId="{F07BBF69-9FD5-4B0C-BEED-CD5FC0D3B778}" dt="2023-01-31T05:09:12.773" v="101" actId="1076"/>
          <ac:spMkLst>
            <pc:docMk/>
            <pc:sldMk cId="3665629369" sldId="260"/>
            <ac:spMk id="11" creationId="{9051B61D-22E5-63D0-3721-98A26783DD99}"/>
          </ac:spMkLst>
        </pc:spChg>
        <pc:spChg chg="mod">
          <ac:chgData name="濵田　大治" userId="3dc346c6-a235-4d96-b756-7f3e038a9511" providerId="ADAL" clId="{F07BBF69-9FD5-4B0C-BEED-CD5FC0D3B778}" dt="2023-01-31T05:07:58.205" v="89" actId="1076"/>
          <ac:spMkLst>
            <pc:docMk/>
            <pc:sldMk cId="3665629369" sldId="260"/>
            <ac:spMk id="13" creationId="{BA0ABD70-22B5-B75E-D56B-B690BF4721B0}"/>
          </ac:spMkLst>
        </pc:spChg>
        <pc:spChg chg="mod">
          <ac:chgData name="濵田　大治" userId="3dc346c6-a235-4d96-b756-7f3e038a9511" providerId="ADAL" clId="{F07BBF69-9FD5-4B0C-BEED-CD5FC0D3B778}" dt="2023-01-31T05:07:58.205" v="89" actId="1076"/>
          <ac:spMkLst>
            <pc:docMk/>
            <pc:sldMk cId="3665629369" sldId="260"/>
            <ac:spMk id="14" creationId="{4A9A80DD-9095-7AA4-9E18-B1D95432DA60}"/>
          </ac:spMkLst>
        </pc:spChg>
        <pc:spChg chg="mod">
          <ac:chgData name="濵田　大治" userId="3dc346c6-a235-4d96-b756-7f3e038a9511" providerId="ADAL" clId="{F07BBF69-9FD5-4B0C-BEED-CD5FC0D3B778}" dt="2023-01-31T05:07:58.205" v="89" actId="1076"/>
          <ac:spMkLst>
            <pc:docMk/>
            <pc:sldMk cId="3665629369" sldId="260"/>
            <ac:spMk id="15" creationId="{E9D7AD65-5FFD-25F0-19E5-82AF3EC11446}"/>
          </ac:spMkLst>
        </pc:spChg>
        <pc:spChg chg="mod">
          <ac:chgData name="濵田　大治" userId="3dc346c6-a235-4d96-b756-7f3e038a9511" providerId="ADAL" clId="{F07BBF69-9FD5-4B0C-BEED-CD5FC0D3B778}" dt="2023-01-31T05:10:01.149" v="112" actId="1076"/>
          <ac:spMkLst>
            <pc:docMk/>
            <pc:sldMk cId="3665629369" sldId="260"/>
            <ac:spMk id="16" creationId="{2C205221-A575-4568-653F-0D3E16861442}"/>
          </ac:spMkLst>
        </pc:spChg>
        <pc:spChg chg="del">
          <ac:chgData name="濵田　大治" userId="3dc346c6-a235-4d96-b756-7f3e038a9511" providerId="ADAL" clId="{F07BBF69-9FD5-4B0C-BEED-CD5FC0D3B778}" dt="2023-01-31T05:08:46.657" v="98" actId="478"/>
          <ac:spMkLst>
            <pc:docMk/>
            <pc:sldMk cId="3665629369" sldId="260"/>
            <ac:spMk id="17" creationId="{B4FBE997-F336-A1C5-AA12-735F9BF4D912}"/>
          </ac:spMkLst>
        </pc:spChg>
        <pc:spChg chg="add mod">
          <ac:chgData name="濵田　大治" userId="3dc346c6-a235-4d96-b756-7f3e038a9511" providerId="ADAL" clId="{F07BBF69-9FD5-4B0C-BEED-CD5FC0D3B778}" dt="2023-01-31T05:07:48.630" v="88" actId="1076"/>
          <ac:spMkLst>
            <pc:docMk/>
            <pc:sldMk cId="3665629369" sldId="260"/>
            <ac:spMk id="18" creationId="{A6C7E8E1-8C0D-084F-D73A-5CEE0C75ED24}"/>
          </ac:spMkLst>
        </pc:spChg>
        <pc:spChg chg="del">
          <ac:chgData name="濵田　大治" userId="3dc346c6-a235-4d96-b756-7f3e038a9511" providerId="ADAL" clId="{F07BBF69-9FD5-4B0C-BEED-CD5FC0D3B778}" dt="2023-01-31T05:07:38.760" v="87" actId="478"/>
          <ac:spMkLst>
            <pc:docMk/>
            <pc:sldMk cId="3665629369" sldId="260"/>
            <ac:spMk id="20" creationId="{4A5B56C5-2831-F674-6EE3-8029B573544C}"/>
          </ac:spMkLst>
        </pc:spChg>
        <pc:spChg chg="del">
          <ac:chgData name="濵田　大治" userId="3dc346c6-a235-4d96-b756-7f3e038a9511" providerId="ADAL" clId="{F07BBF69-9FD5-4B0C-BEED-CD5FC0D3B778}" dt="2023-01-31T05:06:02.687" v="66" actId="478"/>
          <ac:spMkLst>
            <pc:docMk/>
            <pc:sldMk cId="3665629369" sldId="260"/>
            <ac:spMk id="21" creationId="{4C622EB2-32BD-3C12-27B5-FE55471910AF}"/>
          </ac:spMkLst>
        </pc:spChg>
        <pc:spChg chg="del">
          <ac:chgData name="濵田　大治" userId="3dc346c6-a235-4d96-b756-7f3e038a9511" providerId="ADAL" clId="{F07BBF69-9FD5-4B0C-BEED-CD5FC0D3B778}" dt="2023-01-31T05:06:02.687" v="66" actId="478"/>
          <ac:spMkLst>
            <pc:docMk/>
            <pc:sldMk cId="3665629369" sldId="260"/>
            <ac:spMk id="22" creationId="{2CCD35AA-7E5B-2D32-DFE5-1DC139F2DE18}"/>
          </ac:spMkLst>
        </pc:spChg>
        <pc:spChg chg="del">
          <ac:chgData name="濵田　大治" userId="3dc346c6-a235-4d96-b756-7f3e038a9511" providerId="ADAL" clId="{F07BBF69-9FD5-4B0C-BEED-CD5FC0D3B778}" dt="2023-01-31T05:06:02.687" v="66" actId="478"/>
          <ac:spMkLst>
            <pc:docMk/>
            <pc:sldMk cId="3665629369" sldId="260"/>
            <ac:spMk id="23" creationId="{ED2E5685-7346-5FDF-20E4-BB86F28FA964}"/>
          </ac:spMkLst>
        </pc:spChg>
        <pc:spChg chg="del">
          <ac:chgData name="濵田　大治" userId="3dc346c6-a235-4d96-b756-7f3e038a9511" providerId="ADAL" clId="{F07BBF69-9FD5-4B0C-BEED-CD5FC0D3B778}" dt="2023-01-31T05:06:02.687" v="66" actId="478"/>
          <ac:spMkLst>
            <pc:docMk/>
            <pc:sldMk cId="3665629369" sldId="260"/>
            <ac:spMk id="24" creationId="{C0646EA5-E18F-4ECE-8BFE-A95BF6304D6B}"/>
          </ac:spMkLst>
        </pc:spChg>
        <pc:spChg chg="del">
          <ac:chgData name="濵田　大治" userId="3dc346c6-a235-4d96-b756-7f3e038a9511" providerId="ADAL" clId="{F07BBF69-9FD5-4B0C-BEED-CD5FC0D3B778}" dt="2023-01-31T05:06:02.687" v="66" actId="478"/>
          <ac:spMkLst>
            <pc:docMk/>
            <pc:sldMk cId="3665629369" sldId="260"/>
            <ac:spMk id="25" creationId="{8BCFAE96-486B-E68B-3933-B7146BCDC7A4}"/>
          </ac:spMkLst>
        </pc:spChg>
        <pc:spChg chg="del">
          <ac:chgData name="濵田　大治" userId="3dc346c6-a235-4d96-b756-7f3e038a9511" providerId="ADAL" clId="{F07BBF69-9FD5-4B0C-BEED-CD5FC0D3B778}" dt="2023-01-31T05:06:02.687" v="66" actId="478"/>
          <ac:spMkLst>
            <pc:docMk/>
            <pc:sldMk cId="3665629369" sldId="260"/>
            <ac:spMk id="26" creationId="{AEEB2E70-8C1E-CD9A-709B-A691F879C64E}"/>
          </ac:spMkLst>
        </pc:spChg>
        <pc:spChg chg="add del mod">
          <ac:chgData name="濵田　大治" userId="3dc346c6-a235-4d96-b756-7f3e038a9511" providerId="ADAL" clId="{F07BBF69-9FD5-4B0C-BEED-CD5FC0D3B778}" dt="2023-01-31T05:09:19" v="103"/>
          <ac:spMkLst>
            <pc:docMk/>
            <pc:sldMk cId="3665629369" sldId="260"/>
            <ac:spMk id="31" creationId="{76663D89-1A9E-C299-7FBE-A15E9B7CED96}"/>
          </ac:spMkLst>
        </pc:spChg>
        <pc:spChg chg="add del mod">
          <ac:chgData name="濵田　大治" userId="3dc346c6-a235-4d96-b756-7f3e038a9511" providerId="ADAL" clId="{F07BBF69-9FD5-4B0C-BEED-CD5FC0D3B778}" dt="2023-01-31T05:09:19" v="103"/>
          <ac:spMkLst>
            <pc:docMk/>
            <pc:sldMk cId="3665629369" sldId="260"/>
            <ac:spMk id="32" creationId="{E6AC9D26-0BDD-2B1D-DB87-ED102CA5C79D}"/>
          </ac:spMkLst>
        </pc:spChg>
        <pc:spChg chg="add del mod">
          <ac:chgData name="濵田　大治" userId="3dc346c6-a235-4d96-b756-7f3e038a9511" providerId="ADAL" clId="{F07BBF69-9FD5-4B0C-BEED-CD5FC0D3B778}" dt="2023-01-31T05:09:19" v="103"/>
          <ac:spMkLst>
            <pc:docMk/>
            <pc:sldMk cId="3665629369" sldId="260"/>
            <ac:spMk id="34" creationId="{D2DB07E0-5DD9-9582-5C80-5F19AB742F9F}"/>
          </ac:spMkLst>
        </pc:spChg>
        <pc:spChg chg="add mod">
          <ac:chgData name="濵田　大治" userId="3dc346c6-a235-4d96-b756-7f3e038a9511" providerId="ADAL" clId="{F07BBF69-9FD5-4B0C-BEED-CD5FC0D3B778}" dt="2023-01-31T05:09:31.022" v="108" actId="1076"/>
          <ac:spMkLst>
            <pc:docMk/>
            <pc:sldMk cId="3665629369" sldId="260"/>
            <ac:spMk id="35" creationId="{5033288D-B78F-9204-BC70-14DB80BAEAE2}"/>
          </ac:spMkLst>
        </pc:spChg>
        <pc:spChg chg="add mod">
          <ac:chgData name="濵田　大治" userId="3dc346c6-a235-4d96-b756-7f3e038a9511" providerId="ADAL" clId="{F07BBF69-9FD5-4B0C-BEED-CD5FC0D3B778}" dt="2023-01-31T05:10:16.945" v="116" actId="1076"/>
          <ac:spMkLst>
            <pc:docMk/>
            <pc:sldMk cId="3665629369" sldId="260"/>
            <ac:spMk id="36" creationId="{3BF1628E-2D2C-99B9-2AFE-C5D51E1640AA}"/>
          </ac:spMkLst>
        </pc:spChg>
        <pc:picChg chg="add mod">
          <ac:chgData name="濵田　大治" userId="3dc346c6-a235-4d96-b756-7f3e038a9511" providerId="ADAL" clId="{F07BBF69-9FD5-4B0C-BEED-CD5FC0D3B778}" dt="2023-01-31T05:09:38.080" v="109" actId="1076"/>
          <ac:picMkLst>
            <pc:docMk/>
            <pc:sldMk cId="3665629369" sldId="260"/>
            <ac:picMk id="2" creationId="{C6123797-6AFE-07C9-3244-082DB32D98E4}"/>
          </ac:picMkLst>
        </pc:picChg>
        <pc:picChg chg="add mod ord">
          <ac:chgData name="濵田　大治" userId="3dc346c6-a235-4d96-b756-7f3e038a9511" providerId="ADAL" clId="{F07BBF69-9FD5-4B0C-BEED-CD5FC0D3B778}" dt="2023-01-31T05:09:46.933" v="111" actId="167"/>
          <ac:picMkLst>
            <pc:docMk/>
            <pc:sldMk cId="3665629369" sldId="260"/>
            <ac:picMk id="4" creationId="{567C3B01-1DC2-4D9F-1E61-106A0B6ECAA4}"/>
          </ac:picMkLst>
        </pc:picChg>
        <pc:picChg chg="del">
          <ac:chgData name="濵田　大治" userId="3dc346c6-a235-4d96-b756-7f3e038a9511" providerId="ADAL" clId="{F07BBF69-9FD5-4B0C-BEED-CD5FC0D3B778}" dt="2023-01-31T05:08:46.657" v="98" actId="478"/>
          <ac:picMkLst>
            <pc:docMk/>
            <pc:sldMk cId="3665629369" sldId="260"/>
            <ac:picMk id="10" creationId="{E6F5ACB3-6431-C040-4BE0-5BF84A69A617}"/>
          </ac:picMkLst>
        </pc:picChg>
        <pc:picChg chg="add mod ord">
          <ac:chgData name="濵田　大治" userId="3dc346c6-a235-4d96-b756-7f3e038a9511" providerId="ADAL" clId="{F07BBF69-9FD5-4B0C-BEED-CD5FC0D3B778}" dt="2023-01-31T05:08:01.566" v="90" actId="167"/>
          <ac:picMkLst>
            <pc:docMk/>
            <pc:sldMk cId="3665629369" sldId="260"/>
            <ac:picMk id="12" creationId="{563871BA-8A1F-7A72-5435-808700CFA0D3}"/>
          </ac:picMkLst>
        </pc:picChg>
        <pc:picChg chg="del">
          <ac:chgData name="濵田　大治" userId="3dc346c6-a235-4d96-b756-7f3e038a9511" providerId="ADAL" clId="{F07BBF69-9FD5-4B0C-BEED-CD5FC0D3B778}" dt="2023-01-31T05:07:37.857" v="86" actId="478"/>
          <ac:picMkLst>
            <pc:docMk/>
            <pc:sldMk cId="3665629369" sldId="260"/>
            <ac:picMk id="19" creationId="{FB6A593D-5E4D-B8F2-4DDA-E91B3456C14D}"/>
          </ac:picMkLst>
        </pc:picChg>
        <pc:picChg chg="del">
          <ac:chgData name="濵田　大治" userId="3dc346c6-a235-4d96-b756-7f3e038a9511" providerId="ADAL" clId="{F07BBF69-9FD5-4B0C-BEED-CD5FC0D3B778}" dt="2023-01-31T05:06:02.687" v="66" actId="478"/>
          <ac:picMkLst>
            <pc:docMk/>
            <pc:sldMk cId="3665629369" sldId="260"/>
            <ac:picMk id="27" creationId="{822D2D39-E451-1833-BAC0-89C3D26C890E}"/>
          </ac:picMkLst>
        </pc:picChg>
        <pc:picChg chg="del">
          <ac:chgData name="濵田　大治" userId="3dc346c6-a235-4d96-b756-7f3e038a9511" providerId="ADAL" clId="{F07BBF69-9FD5-4B0C-BEED-CD5FC0D3B778}" dt="2023-01-31T05:06:02.687" v="66" actId="478"/>
          <ac:picMkLst>
            <pc:docMk/>
            <pc:sldMk cId="3665629369" sldId="260"/>
            <ac:picMk id="28" creationId="{28452614-43A4-00E3-5CC8-0F1A183866F1}"/>
          </ac:picMkLst>
        </pc:picChg>
        <pc:picChg chg="add del mod">
          <ac:chgData name="濵田　大治" userId="3dc346c6-a235-4d96-b756-7f3e038a9511" providerId="ADAL" clId="{F07BBF69-9FD5-4B0C-BEED-CD5FC0D3B778}" dt="2023-01-31T05:09:19" v="103"/>
          <ac:picMkLst>
            <pc:docMk/>
            <pc:sldMk cId="3665629369" sldId="260"/>
            <ac:picMk id="29" creationId="{1A86D750-7EF8-37C4-8618-53647FAF7B2E}"/>
          </ac:picMkLst>
        </pc:picChg>
        <pc:picChg chg="add del mod">
          <ac:chgData name="濵田　大治" userId="3dc346c6-a235-4d96-b756-7f3e038a9511" providerId="ADAL" clId="{F07BBF69-9FD5-4B0C-BEED-CD5FC0D3B778}" dt="2023-01-31T05:09:19" v="103"/>
          <ac:picMkLst>
            <pc:docMk/>
            <pc:sldMk cId="3665629369" sldId="260"/>
            <ac:picMk id="30" creationId="{255B2058-4031-3C5C-F3E8-E57C76C39200}"/>
          </ac:picMkLst>
        </pc:picChg>
        <pc:picChg chg="add del mod">
          <ac:chgData name="濵田　大治" userId="3dc346c6-a235-4d96-b756-7f3e038a9511" providerId="ADAL" clId="{F07BBF69-9FD5-4B0C-BEED-CD5FC0D3B778}" dt="2023-01-31T05:09:19" v="103"/>
          <ac:picMkLst>
            <pc:docMk/>
            <pc:sldMk cId="3665629369" sldId="260"/>
            <ac:picMk id="33" creationId="{CC14197C-FD3B-956C-AB35-140B601BBE97}"/>
          </ac:picMkLst>
        </pc:picChg>
      </pc:sldChg>
    </pc:docChg>
  </pc:docChgLst>
  <pc:docChgLst>
    <pc:chgData name="濵田　大治" userId="3dc346c6-a235-4d96-b756-7f3e038a9511" providerId="ADAL" clId="{265472C0-0AD8-4F9D-9100-4602D5E3EE92}"/>
    <pc:docChg chg="undo redo custSel modSld">
      <pc:chgData name="濵田　大治" userId="3dc346c6-a235-4d96-b756-7f3e038a9511" providerId="ADAL" clId="{265472C0-0AD8-4F9D-9100-4602D5E3EE92}" dt="2023-04-04T09:19:04.952" v="388" actId="1076"/>
      <pc:docMkLst>
        <pc:docMk/>
      </pc:docMkLst>
      <pc:sldChg chg="addSp delSp modSp mod">
        <pc:chgData name="濵田　大治" userId="3dc346c6-a235-4d96-b756-7f3e038a9511" providerId="ADAL" clId="{265472C0-0AD8-4F9D-9100-4602D5E3EE92}" dt="2023-04-04T09:19:04.952" v="388" actId="1076"/>
        <pc:sldMkLst>
          <pc:docMk/>
          <pc:sldMk cId="482546094" sldId="257"/>
        </pc:sldMkLst>
        <pc:spChg chg="mod">
          <ac:chgData name="濵田　大治" userId="3dc346c6-a235-4d96-b756-7f3e038a9511" providerId="ADAL" clId="{265472C0-0AD8-4F9D-9100-4602D5E3EE92}" dt="2023-04-04T09:16:23.974" v="325" actId="1076"/>
          <ac:spMkLst>
            <pc:docMk/>
            <pc:sldMk cId="482546094" sldId="257"/>
            <ac:spMk id="4" creationId="{48D8ADA3-D8E1-D1E5-3260-4C17F8980780}"/>
          </ac:spMkLst>
        </pc:spChg>
        <pc:spChg chg="mod">
          <ac:chgData name="濵田　大治" userId="3dc346c6-a235-4d96-b756-7f3e038a9511" providerId="ADAL" clId="{265472C0-0AD8-4F9D-9100-4602D5E3EE92}" dt="2023-04-04T09:16:23.974" v="325" actId="1076"/>
          <ac:spMkLst>
            <pc:docMk/>
            <pc:sldMk cId="482546094" sldId="257"/>
            <ac:spMk id="5" creationId="{B4A764C2-6899-6F81-58EC-62FE6233A1EA}"/>
          </ac:spMkLst>
        </pc:spChg>
        <pc:spChg chg="mod">
          <ac:chgData name="濵田　大治" userId="3dc346c6-a235-4d96-b756-7f3e038a9511" providerId="ADAL" clId="{265472C0-0AD8-4F9D-9100-4602D5E3EE92}" dt="2023-04-04T09:16:23.974" v="325" actId="1076"/>
          <ac:spMkLst>
            <pc:docMk/>
            <pc:sldMk cId="482546094" sldId="257"/>
            <ac:spMk id="7" creationId="{50FEC825-AE2B-9FF0-CDEF-B99EA12E07A3}"/>
          </ac:spMkLst>
        </pc:spChg>
        <pc:spChg chg="mod">
          <ac:chgData name="濵田　大治" userId="3dc346c6-a235-4d96-b756-7f3e038a9511" providerId="ADAL" clId="{265472C0-0AD8-4F9D-9100-4602D5E3EE92}" dt="2023-04-04T09:16:23.974" v="325" actId="1076"/>
          <ac:spMkLst>
            <pc:docMk/>
            <pc:sldMk cId="482546094" sldId="257"/>
            <ac:spMk id="8" creationId="{72C1DD76-8AA7-C565-242E-80107ED73F08}"/>
          </ac:spMkLst>
        </pc:spChg>
        <pc:spChg chg="add mod">
          <ac:chgData name="濵田　大治" userId="3dc346c6-a235-4d96-b756-7f3e038a9511" providerId="ADAL" clId="{265472C0-0AD8-4F9D-9100-4602D5E3EE92}" dt="2023-04-04T09:17:48.008" v="354" actId="20577"/>
          <ac:spMkLst>
            <pc:docMk/>
            <pc:sldMk cId="482546094" sldId="257"/>
            <ac:spMk id="10" creationId="{083146D1-D8EE-7B79-320D-3015D9CFD045}"/>
          </ac:spMkLst>
        </pc:spChg>
        <pc:spChg chg="mod">
          <ac:chgData name="濵田　大治" userId="3dc346c6-a235-4d96-b756-7f3e038a9511" providerId="ADAL" clId="{265472C0-0AD8-4F9D-9100-4602D5E3EE92}" dt="2023-04-04T09:16:23.974" v="325" actId="1076"/>
          <ac:spMkLst>
            <pc:docMk/>
            <pc:sldMk cId="482546094" sldId="257"/>
            <ac:spMk id="13" creationId="{BA0ABD70-22B5-B75E-D56B-B690BF4721B0}"/>
          </ac:spMkLst>
        </pc:spChg>
        <pc:spChg chg="mod">
          <ac:chgData name="濵田　大治" userId="3dc346c6-a235-4d96-b756-7f3e038a9511" providerId="ADAL" clId="{265472C0-0AD8-4F9D-9100-4602D5E3EE92}" dt="2023-04-04T09:16:23.974" v="325" actId="1076"/>
          <ac:spMkLst>
            <pc:docMk/>
            <pc:sldMk cId="482546094" sldId="257"/>
            <ac:spMk id="14" creationId="{4A9A80DD-9095-7AA4-9E18-B1D95432DA60}"/>
          </ac:spMkLst>
        </pc:spChg>
        <pc:spChg chg="mod">
          <ac:chgData name="濵田　大治" userId="3dc346c6-a235-4d96-b756-7f3e038a9511" providerId="ADAL" clId="{265472C0-0AD8-4F9D-9100-4602D5E3EE92}" dt="2023-04-04T09:16:23.974" v="325" actId="1076"/>
          <ac:spMkLst>
            <pc:docMk/>
            <pc:sldMk cId="482546094" sldId="257"/>
            <ac:spMk id="15" creationId="{E9D7AD65-5FFD-25F0-19E5-82AF3EC11446}"/>
          </ac:spMkLst>
        </pc:spChg>
        <pc:spChg chg="mod">
          <ac:chgData name="濵田　大治" userId="3dc346c6-a235-4d96-b756-7f3e038a9511" providerId="ADAL" clId="{265472C0-0AD8-4F9D-9100-4602D5E3EE92}" dt="2023-04-04T09:16:23.974" v="325" actId="1076"/>
          <ac:spMkLst>
            <pc:docMk/>
            <pc:sldMk cId="482546094" sldId="257"/>
            <ac:spMk id="16" creationId="{2C205221-A575-4568-653F-0D3E16861442}"/>
          </ac:spMkLst>
        </pc:spChg>
        <pc:spChg chg="add mod">
          <ac:chgData name="濵田　大治" userId="3dc346c6-a235-4d96-b756-7f3e038a9511" providerId="ADAL" clId="{265472C0-0AD8-4F9D-9100-4602D5E3EE92}" dt="2023-04-04T09:19:04.952" v="388" actId="1076"/>
          <ac:spMkLst>
            <pc:docMk/>
            <pc:sldMk cId="482546094" sldId="257"/>
            <ac:spMk id="17" creationId="{03D83306-CBA2-7A82-DD33-75BED68CAD04}"/>
          </ac:spMkLst>
        </pc:spChg>
        <pc:picChg chg="mod">
          <ac:chgData name="濵田　大治" userId="3dc346c6-a235-4d96-b756-7f3e038a9511" providerId="ADAL" clId="{265472C0-0AD8-4F9D-9100-4602D5E3EE92}" dt="2023-04-04T09:16:23.974" v="325" actId="1076"/>
          <ac:picMkLst>
            <pc:docMk/>
            <pc:sldMk cId="482546094" sldId="257"/>
            <ac:picMk id="2" creationId="{E1C4239A-1D9A-7CF4-66B7-BC2BE5C49E02}"/>
          </ac:picMkLst>
        </pc:picChg>
        <pc:picChg chg="del mod">
          <ac:chgData name="濵田　大治" userId="3dc346c6-a235-4d96-b756-7f3e038a9511" providerId="ADAL" clId="{265472C0-0AD8-4F9D-9100-4602D5E3EE92}" dt="2023-04-04T08:49:57.503" v="309" actId="478"/>
          <ac:picMkLst>
            <pc:docMk/>
            <pc:sldMk cId="482546094" sldId="257"/>
            <ac:picMk id="3" creationId="{81E55A20-E7CA-805E-B74D-FF73F8221B40}"/>
          </ac:picMkLst>
        </pc:picChg>
        <pc:picChg chg="add mod">
          <ac:chgData name="濵田　大治" userId="3dc346c6-a235-4d96-b756-7f3e038a9511" providerId="ADAL" clId="{265472C0-0AD8-4F9D-9100-4602D5E3EE92}" dt="2023-04-04T09:17:29.546" v="333" actId="1076"/>
          <ac:picMkLst>
            <pc:docMk/>
            <pc:sldMk cId="482546094" sldId="257"/>
            <ac:picMk id="9" creationId="{1EEA46C0-DB32-C91C-52B7-B7225D7203D0}"/>
          </ac:picMkLst>
        </pc:picChg>
        <pc:picChg chg="add del mod">
          <ac:chgData name="濵田　大治" userId="3dc346c6-a235-4d96-b756-7f3e038a9511" providerId="ADAL" clId="{265472C0-0AD8-4F9D-9100-4602D5E3EE92}" dt="2023-04-04T08:45:31.096" v="291" actId="478"/>
          <ac:picMkLst>
            <pc:docMk/>
            <pc:sldMk cId="482546094" sldId="257"/>
            <ac:picMk id="10" creationId="{C6E7925C-B5D7-DDED-0A77-DC00775C2573}"/>
          </ac:picMkLst>
        </pc:picChg>
        <pc:picChg chg="add del mod">
          <ac:chgData name="濵田　大治" userId="3dc346c6-a235-4d96-b756-7f3e038a9511" providerId="ADAL" clId="{265472C0-0AD8-4F9D-9100-4602D5E3EE92}" dt="2023-04-04T08:48:16.994" v="301" actId="478"/>
          <ac:picMkLst>
            <pc:docMk/>
            <pc:sldMk cId="482546094" sldId="257"/>
            <ac:picMk id="12" creationId="{7254B515-CFBE-DE81-C53A-3BDA3FD0B2F6}"/>
          </ac:picMkLst>
        </pc:picChg>
        <pc:picChg chg="add mod ord">
          <ac:chgData name="濵田　大治" userId="3dc346c6-a235-4d96-b756-7f3e038a9511" providerId="ADAL" clId="{265472C0-0AD8-4F9D-9100-4602D5E3EE92}" dt="2023-04-04T09:16:23.974" v="325" actId="1076"/>
          <ac:picMkLst>
            <pc:docMk/>
            <pc:sldMk cId="482546094" sldId="257"/>
            <ac:picMk id="18" creationId="{8DD24D82-2677-54AA-C424-71056340B440}"/>
          </ac:picMkLst>
        </pc:picChg>
        <pc:picChg chg="add del mod">
          <ac:chgData name="濵田　大治" userId="3dc346c6-a235-4d96-b756-7f3e038a9511" providerId="ADAL" clId="{265472C0-0AD8-4F9D-9100-4602D5E3EE92}" dt="2023-04-04T08:55:10.266" v="322" actId="478"/>
          <ac:picMkLst>
            <pc:docMk/>
            <pc:sldMk cId="482546094" sldId="257"/>
            <ac:picMk id="20" creationId="{347F86A7-F37B-B9B5-2698-70CEACFF3D09}"/>
          </ac:picMkLst>
        </pc:picChg>
        <pc:cxnChg chg="add mod">
          <ac:chgData name="濵田　大治" userId="3dc346c6-a235-4d96-b756-7f3e038a9511" providerId="ADAL" clId="{265472C0-0AD8-4F9D-9100-4602D5E3EE92}" dt="2023-04-04T09:18:22.580" v="362" actId="1076"/>
          <ac:cxnSpMkLst>
            <pc:docMk/>
            <pc:sldMk cId="482546094" sldId="257"/>
            <ac:cxnSpMk id="12" creationId="{6321D6E9-BCDF-DC2B-CD41-71CF214BA139}"/>
          </ac:cxnSpMkLst>
        </pc:cxnChg>
      </pc:sldChg>
      <pc:sldChg chg="addSp delSp modSp mod">
        <pc:chgData name="濵田　大治" userId="3dc346c6-a235-4d96-b756-7f3e038a9511" providerId="ADAL" clId="{265472C0-0AD8-4F9D-9100-4602D5E3EE92}" dt="2023-04-04T08:09:47.122" v="283" actId="1076"/>
        <pc:sldMkLst>
          <pc:docMk/>
          <pc:sldMk cId="15362827" sldId="258"/>
        </pc:sldMkLst>
        <pc:spChg chg="mod">
          <ac:chgData name="濵田　大治" userId="3dc346c6-a235-4d96-b756-7f3e038a9511" providerId="ADAL" clId="{265472C0-0AD8-4F9D-9100-4602D5E3EE92}" dt="2023-04-04T08:09:47.122" v="283" actId="1076"/>
          <ac:spMkLst>
            <pc:docMk/>
            <pc:sldMk cId="15362827" sldId="258"/>
            <ac:spMk id="7" creationId="{50FEC825-AE2B-9FF0-CDEF-B99EA12E07A3}"/>
          </ac:spMkLst>
        </pc:spChg>
        <pc:spChg chg="mod">
          <ac:chgData name="濵田　大治" userId="3dc346c6-a235-4d96-b756-7f3e038a9511" providerId="ADAL" clId="{265472C0-0AD8-4F9D-9100-4602D5E3EE92}" dt="2023-04-04T08:09:27.052" v="279" actId="1076"/>
          <ac:spMkLst>
            <pc:docMk/>
            <pc:sldMk cId="15362827" sldId="258"/>
            <ac:spMk id="8" creationId="{72C1DD76-8AA7-C565-242E-80107ED73F08}"/>
          </ac:spMkLst>
        </pc:spChg>
        <pc:spChg chg="mod">
          <ac:chgData name="濵田　大治" userId="3dc346c6-a235-4d96-b756-7f3e038a9511" providerId="ADAL" clId="{265472C0-0AD8-4F9D-9100-4602D5E3EE92}" dt="2023-04-04T08:09:47.122" v="283" actId="1076"/>
          <ac:spMkLst>
            <pc:docMk/>
            <pc:sldMk cId="15362827" sldId="258"/>
            <ac:spMk id="11" creationId="{E6EF5794-ACD2-1C54-4CDC-2C60CAA6E053}"/>
          </ac:spMkLst>
        </pc:spChg>
        <pc:spChg chg="mod">
          <ac:chgData name="濵田　大治" userId="3dc346c6-a235-4d96-b756-7f3e038a9511" providerId="ADAL" clId="{265472C0-0AD8-4F9D-9100-4602D5E3EE92}" dt="2023-04-04T08:09:27.052" v="279" actId="1076"/>
          <ac:spMkLst>
            <pc:docMk/>
            <pc:sldMk cId="15362827" sldId="258"/>
            <ac:spMk id="12" creationId="{F2904211-4805-885F-5465-CC578AFAF2A2}"/>
          </ac:spMkLst>
        </pc:spChg>
        <pc:spChg chg="del mod">
          <ac:chgData name="濵田　大治" userId="3dc346c6-a235-4d96-b756-7f3e038a9511" providerId="ADAL" clId="{265472C0-0AD8-4F9D-9100-4602D5E3EE92}" dt="2023-04-04T08:09:17.318" v="276" actId="478"/>
          <ac:spMkLst>
            <pc:docMk/>
            <pc:sldMk cId="15362827" sldId="258"/>
            <ac:spMk id="13" creationId="{BA0ABD70-22B5-B75E-D56B-B690BF4721B0}"/>
          </ac:spMkLst>
        </pc:spChg>
        <pc:spChg chg="del mod">
          <ac:chgData name="濵田　大治" userId="3dc346c6-a235-4d96-b756-7f3e038a9511" providerId="ADAL" clId="{265472C0-0AD8-4F9D-9100-4602D5E3EE92}" dt="2023-04-04T08:09:17.318" v="276" actId="478"/>
          <ac:spMkLst>
            <pc:docMk/>
            <pc:sldMk cId="15362827" sldId="258"/>
            <ac:spMk id="14" creationId="{4A9A80DD-9095-7AA4-9E18-B1D95432DA60}"/>
          </ac:spMkLst>
        </pc:spChg>
        <pc:spChg chg="del mod">
          <ac:chgData name="濵田　大治" userId="3dc346c6-a235-4d96-b756-7f3e038a9511" providerId="ADAL" clId="{265472C0-0AD8-4F9D-9100-4602D5E3EE92}" dt="2023-04-04T08:09:17.318" v="276" actId="478"/>
          <ac:spMkLst>
            <pc:docMk/>
            <pc:sldMk cId="15362827" sldId="258"/>
            <ac:spMk id="15" creationId="{E9D7AD65-5FFD-25F0-19E5-82AF3EC11446}"/>
          </ac:spMkLst>
        </pc:spChg>
        <pc:spChg chg="del mod">
          <ac:chgData name="濵田　大治" userId="3dc346c6-a235-4d96-b756-7f3e038a9511" providerId="ADAL" clId="{265472C0-0AD8-4F9D-9100-4602D5E3EE92}" dt="2023-04-04T08:09:17.318" v="276" actId="478"/>
          <ac:spMkLst>
            <pc:docMk/>
            <pc:sldMk cId="15362827" sldId="258"/>
            <ac:spMk id="16" creationId="{2C205221-A575-4568-653F-0D3E16861442}"/>
          </ac:spMkLst>
        </pc:spChg>
        <pc:picChg chg="add del mod modCrop">
          <ac:chgData name="濵田　大治" userId="3dc346c6-a235-4d96-b756-7f3e038a9511" providerId="ADAL" clId="{265472C0-0AD8-4F9D-9100-4602D5E3EE92}" dt="2023-04-04T08:05:27.440" v="235" actId="478"/>
          <ac:picMkLst>
            <pc:docMk/>
            <pc:sldMk cId="15362827" sldId="258"/>
            <ac:picMk id="3" creationId="{0E0B3A6A-4837-033D-F6C7-9343B406C5CB}"/>
          </ac:picMkLst>
        </pc:picChg>
        <pc:picChg chg="add mod ord">
          <ac:chgData name="濵田　大治" userId="3dc346c6-a235-4d96-b756-7f3e038a9511" providerId="ADAL" clId="{265472C0-0AD8-4F9D-9100-4602D5E3EE92}" dt="2023-04-04T08:09:47.122" v="283" actId="1076"/>
          <ac:picMkLst>
            <pc:docMk/>
            <pc:sldMk cId="15362827" sldId="258"/>
            <ac:picMk id="4" creationId="{03F5B7AC-381B-B460-6FE9-C1B04610D541}"/>
          </ac:picMkLst>
        </pc:picChg>
        <pc:picChg chg="del mod">
          <ac:chgData name="濵田　大治" userId="3dc346c6-a235-4d96-b756-7f3e038a9511" providerId="ADAL" clId="{265472C0-0AD8-4F9D-9100-4602D5E3EE92}" dt="2023-04-04T08:09:17.318" v="276" actId="478"/>
          <ac:picMkLst>
            <pc:docMk/>
            <pc:sldMk cId="15362827" sldId="258"/>
            <ac:picMk id="9" creationId="{5D95017C-55CF-21CD-85F3-6E6E9865B026}"/>
          </ac:picMkLst>
        </pc:picChg>
        <pc:picChg chg="add del mod modCrop">
          <ac:chgData name="濵田　大治" userId="3dc346c6-a235-4d96-b756-7f3e038a9511" providerId="ADAL" clId="{265472C0-0AD8-4F9D-9100-4602D5E3EE92}" dt="2023-04-04T08:07:38.787" v="253" actId="478"/>
          <ac:picMkLst>
            <pc:docMk/>
            <pc:sldMk cId="15362827" sldId="258"/>
            <ac:picMk id="10" creationId="{A46B30DA-C798-9A64-9A71-BE2BCE5F8545}"/>
          </ac:picMkLst>
        </pc:picChg>
        <pc:picChg chg="add mod ord">
          <ac:chgData name="濵田　大治" userId="3dc346c6-a235-4d96-b756-7f3e038a9511" providerId="ADAL" clId="{265472C0-0AD8-4F9D-9100-4602D5E3EE92}" dt="2023-04-04T08:09:27.052" v="279" actId="1076"/>
          <ac:picMkLst>
            <pc:docMk/>
            <pc:sldMk cId="15362827" sldId="258"/>
            <ac:picMk id="17" creationId="{E2C39667-D693-4D27-7821-EF92324630BD}"/>
          </ac:picMkLst>
        </pc:picChg>
        <pc:picChg chg="del mod">
          <ac:chgData name="濵田　大治" userId="3dc346c6-a235-4d96-b756-7f3e038a9511" providerId="ADAL" clId="{265472C0-0AD8-4F9D-9100-4602D5E3EE92}" dt="2023-04-04T08:09:17.318" v="276" actId="478"/>
          <ac:picMkLst>
            <pc:docMk/>
            <pc:sldMk cId="15362827" sldId="258"/>
            <ac:picMk id="18" creationId="{62FFA1C6-6811-1BEF-971E-5FB7A0E3162C}"/>
          </ac:picMkLst>
        </pc:picChg>
      </pc:sldChg>
      <pc:sldChg chg="addSp delSp modSp mod">
        <pc:chgData name="濵田　大治" userId="3dc346c6-a235-4d96-b756-7f3e038a9511" providerId="ADAL" clId="{265472C0-0AD8-4F9D-9100-4602D5E3EE92}" dt="2023-04-04T08:02:18.460" v="225" actId="1076"/>
        <pc:sldMkLst>
          <pc:docMk/>
          <pc:sldMk cId="1105138256" sldId="259"/>
        </pc:sldMkLst>
        <pc:spChg chg="mod">
          <ac:chgData name="濵田　大治" userId="3dc346c6-a235-4d96-b756-7f3e038a9511" providerId="ADAL" clId="{265472C0-0AD8-4F9D-9100-4602D5E3EE92}" dt="2023-04-04T08:02:13.320" v="224" actId="1076"/>
          <ac:spMkLst>
            <pc:docMk/>
            <pc:sldMk cId="1105138256" sldId="259"/>
            <ac:spMk id="3" creationId="{5E4A5850-5FB8-976F-2978-B81D21F57590}"/>
          </ac:spMkLst>
        </pc:spChg>
        <pc:spChg chg="mod">
          <ac:chgData name="濵田　大治" userId="3dc346c6-a235-4d96-b756-7f3e038a9511" providerId="ADAL" clId="{265472C0-0AD8-4F9D-9100-4602D5E3EE92}" dt="2023-04-04T08:01:10.036" v="209" actId="1076"/>
          <ac:spMkLst>
            <pc:docMk/>
            <pc:sldMk cId="1105138256" sldId="259"/>
            <ac:spMk id="5" creationId="{AC04AF93-84B7-9D73-6456-9C61CAA2754D}"/>
          </ac:spMkLst>
        </pc:spChg>
        <pc:spChg chg="mod">
          <ac:chgData name="濵田　大治" userId="3dc346c6-a235-4d96-b756-7f3e038a9511" providerId="ADAL" clId="{265472C0-0AD8-4F9D-9100-4602D5E3EE92}" dt="2023-04-04T07:57:16.437" v="197" actId="1076"/>
          <ac:spMkLst>
            <pc:docMk/>
            <pc:sldMk cId="1105138256" sldId="259"/>
            <ac:spMk id="7" creationId="{50FEC825-AE2B-9FF0-CDEF-B99EA12E07A3}"/>
          </ac:spMkLst>
        </pc:spChg>
        <pc:spChg chg="mod">
          <ac:chgData name="濵田　大治" userId="3dc346c6-a235-4d96-b756-7f3e038a9511" providerId="ADAL" clId="{265472C0-0AD8-4F9D-9100-4602D5E3EE92}" dt="2023-04-04T07:52:04.846" v="149" actId="1076"/>
          <ac:spMkLst>
            <pc:docMk/>
            <pc:sldMk cId="1105138256" sldId="259"/>
            <ac:spMk id="8" creationId="{72C1DD76-8AA7-C565-242E-80107ED73F08}"/>
          </ac:spMkLst>
        </pc:spChg>
        <pc:spChg chg="del mod">
          <ac:chgData name="濵田　大治" userId="3dc346c6-a235-4d96-b756-7f3e038a9511" providerId="ADAL" clId="{265472C0-0AD8-4F9D-9100-4602D5E3EE92}" dt="2023-04-04T07:57:00.079" v="196" actId="478"/>
          <ac:spMkLst>
            <pc:docMk/>
            <pc:sldMk cId="1105138256" sldId="259"/>
            <ac:spMk id="13" creationId="{BA0ABD70-22B5-B75E-D56B-B690BF4721B0}"/>
          </ac:spMkLst>
        </pc:spChg>
        <pc:spChg chg="del mod">
          <ac:chgData name="濵田　大治" userId="3dc346c6-a235-4d96-b756-7f3e038a9511" providerId="ADAL" clId="{265472C0-0AD8-4F9D-9100-4602D5E3EE92}" dt="2023-04-04T07:57:00.079" v="196" actId="478"/>
          <ac:spMkLst>
            <pc:docMk/>
            <pc:sldMk cId="1105138256" sldId="259"/>
            <ac:spMk id="14" creationId="{4A9A80DD-9095-7AA4-9E18-B1D95432DA60}"/>
          </ac:spMkLst>
        </pc:spChg>
        <pc:spChg chg="del mod">
          <ac:chgData name="濵田　大治" userId="3dc346c6-a235-4d96-b756-7f3e038a9511" providerId="ADAL" clId="{265472C0-0AD8-4F9D-9100-4602D5E3EE92}" dt="2023-04-04T07:57:00.079" v="196" actId="478"/>
          <ac:spMkLst>
            <pc:docMk/>
            <pc:sldMk cId="1105138256" sldId="259"/>
            <ac:spMk id="15" creationId="{E9D7AD65-5FFD-25F0-19E5-82AF3EC11446}"/>
          </ac:spMkLst>
        </pc:spChg>
        <pc:spChg chg="del mod">
          <ac:chgData name="濵田　大治" userId="3dc346c6-a235-4d96-b756-7f3e038a9511" providerId="ADAL" clId="{265472C0-0AD8-4F9D-9100-4602D5E3EE92}" dt="2023-04-04T07:51:51.579" v="147" actId="478"/>
          <ac:spMkLst>
            <pc:docMk/>
            <pc:sldMk cId="1105138256" sldId="259"/>
            <ac:spMk id="16" creationId="{2C205221-A575-4568-653F-0D3E16861442}"/>
          </ac:spMkLst>
        </pc:spChg>
        <pc:spChg chg="mod">
          <ac:chgData name="濵田　大治" userId="3dc346c6-a235-4d96-b756-7f3e038a9511" providerId="ADAL" clId="{265472C0-0AD8-4F9D-9100-4602D5E3EE92}" dt="2023-04-04T07:52:04.846" v="149" actId="1076"/>
          <ac:spMkLst>
            <pc:docMk/>
            <pc:sldMk cId="1105138256" sldId="259"/>
            <ac:spMk id="17" creationId="{B4FBE997-F336-A1C5-AA12-735F9BF4D912}"/>
          </ac:spMkLst>
        </pc:spChg>
        <pc:spChg chg="mod">
          <ac:chgData name="濵田　大治" userId="3dc346c6-a235-4d96-b756-7f3e038a9511" providerId="ADAL" clId="{265472C0-0AD8-4F9D-9100-4602D5E3EE92}" dt="2023-04-04T07:57:16.437" v="197" actId="1076"/>
          <ac:spMkLst>
            <pc:docMk/>
            <pc:sldMk cId="1105138256" sldId="259"/>
            <ac:spMk id="20" creationId="{4A5B56C5-2831-F674-6EE3-8029B573544C}"/>
          </ac:spMkLst>
        </pc:spChg>
        <pc:spChg chg="mod">
          <ac:chgData name="濵田　大治" userId="3dc346c6-a235-4d96-b756-7f3e038a9511" providerId="ADAL" clId="{265472C0-0AD8-4F9D-9100-4602D5E3EE92}" dt="2023-04-04T08:02:18.460" v="225" actId="1076"/>
          <ac:spMkLst>
            <pc:docMk/>
            <pc:sldMk cId="1105138256" sldId="259"/>
            <ac:spMk id="21" creationId="{4C622EB2-32BD-3C12-27B5-FE55471910AF}"/>
          </ac:spMkLst>
        </pc:spChg>
        <pc:spChg chg="mod">
          <ac:chgData name="濵田　大治" userId="3dc346c6-a235-4d96-b756-7f3e038a9511" providerId="ADAL" clId="{265472C0-0AD8-4F9D-9100-4602D5E3EE92}" dt="2023-04-04T08:01:10.036" v="209" actId="1076"/>
          <ac:spMkLst>
            <pc:docMk/>
            <pc:sldMk cId="1105138256" sldId="259"/>
            <ac:spMk id="22" creationId="{2CCD35AA-7E5B-2D32-DFE5-1DC139F2DE18}"/>
          </ac:spMkLst>
        </pc:spChg>
        <pc:spChg chg="del mod">
          <ac:chgData name="濵田　大治" userId="3dc346c6-a235-4d96-b756-7f3e038a9511" providerId="ADAL" clId="{265472C0-0AD8-4F9D-9100-4602D5E3EE92}" dt="2023-04-04T08:01:41.515" v="215" actId="478"/>
          <ac:spMkLst>
            <pc:docMk/>
            <pc:sldMk cId="1105138256" sldId="259"/>
            <ac:spMk id="23" creationId="{ED2E5685-7346-5FDF-20E4-BB86F28FA964}"/>
          </ac:spMkLst>
        </pc:spChg>
        <pc:spChg chg="del mod">
          <ac:chgData name="濵田　大治" userId="3dc346c6-a235-4d96-b756-7f3e038a9511" providerId="ADAL" clId="{265472C0-0AD8-4F9D-9100-4602D5E3EE92}" dt="2023-04-04T08:01:41.515" v="215" actId="478"/>
          <ac:spMkLst>
            <pc:docMk/>
            <pc:sldMk cId="1105138256" sldId="259"/>
            <ac:spMk id="24" creationId="{C0646EA5-E18F-4ECE-8BFE-A95BF6304D6B}"/>
          </ac:spMkLst>
        </pc:spChg>
        <pc:spChg chg="del mod">
          <ac:chgData name="濵田　大治" userId="3dc346c6-a235-4d96-b756-7f3e038a9511" providerId="ADAL" clId="{265472C0-0AD8-4F9D-9100-4602D5E3EE92}" dt="2023-04-04T08:01:41.515" v="215" actId="478"/>
          <ac:spMkLst>
            <pc:docMk/>
            <pc:sldMk cId="1105138256" sldId="259"/>
            <ac:spMk id="25" creationId="{8BCFAE96-486B-E68B-3933-B7146BCDC7A4}"/>
          </ac:spMkLst>
        </pc:spChg>
        <pc:spChg chg="del mod">
          <ac:chgData name="濵田　大治" userId="3dc346c6-a235-4d96-b756-7f3e038a9511" providerId="ADAL" clId="{265472C0-0AD8-4F9D-9100-4602D5E3EE92}" dt="2023-04-04T07:48:43.993" v="121" actId="478"/>
          <ac:spMkLst>
            <pc:docMk/>
            <pc:sldMk cId="1105138256" sldId="259"/>
            <ac:spMk id="26" creationId="{AEEB2E70-8C1E-CD9A-709B-A691F879C64E}"/>
          </ac:spMkLst>
        </pc:spChg>
        <pc:picChg chg="add del mod modCrop">
          <ac:chgData name="濵田　大治" userId="3dc346c6-a235-4d96-b756-7f3e038a9511" providerId="ADAL" clId="{265472C0-0AD8-4F9D-9100-4602D5E3EE92}" dt="2023-04-04T07:36:25.716" v="65" actId="478"/>
          <ac:picMkLst>
            <pc:docMk/>
            <pc:sldMk cId="1105138256" sldId="259"/>
            <ac:picMk id="4" creationId="{7A5FDF87-33DA-51F5-6125-A52C6647C8D9}"/>
          </ac:picMkLst>
        </pc:picChg>
        <pc:picChg chg="add mod ord">
          <ac:chgData name="濵田　大治" userId="3dc346c6-a235-4d96-b756-7f3e038a9511" providerId="ADAL" clId="{265472C0-0AD8-4F9D-9100-4602D5E3EE92}" dt="2023-04-04T08:01:10.036" v="209" actId="1076"/>
          <ac:picMkLst>
            <pc:docMk/>
            <pc:sldMk cId="1105138256" sldId="259"/>
            <ac:picMk id="9" creationId="{81D04D21-0EFA-DA55-8E67-1788AC539066}"/>
          </ac:picMkLst>
        </pc:picChg>
        <pc:picChg chg="add del mod">
          <ac:chgData name="濵田　大治" userId="3dc346c6-a235-4d96-b756-7f3e038a9511" providerId="ADAL" clId="{265472C0-0AD8-4F9D-9100-4602D5E3EE92}" dt="2023-04-04T07:51:22.909" v="141" actId="478"/>
          <ac:picMkLst>
            <pc:docMk/>
            <pc:sldMk cId="1105138256" sldId="259"/>
            <ac:picMk id="10" creationId="{E6F5ACB3-6431-C040-4BE0-5BF84A69A617}"/>
          </ac:picMkLst>
        </pc:picChg>
        <pc:picChg chg="add del mod modCrop">
          <ac:chgData name="濵田　大治" userId="3dc346c6-a235-4d96-b756-7f3e038a9511" providerId="ADAL" clId="{265472C0-0AD8-4F9D-9100-4602D5E3EE92}" dt="2023-04-04T07:50:40.568" v="132" actId="478"/>
          <ac:picMkLst>
            <pc:docMk/>
            <pc:sldMk cId="1105138256" sldId="259"/>
            <ac:picMk id="12" creationId="{D69E2D19-C1DB-5168-27C5-4FC3CAD48433}"/>
          </ac:picMkLst>
        </pc:picChg>
        <pc:picChg chg="add mod ord">
          <ac:chgData name="濵田　大治" userId="3dc346c6-a235-4d96-b756-7f3e038a9511" providerId="ADAL" clId="{265472C0-0AD8-4F9D-9100-4602D5E3EE92}" dt="2023-04-04T07:52:04.846" v="149" actId="1076"/>
          <ac:picMkLst>
            <pc:docMk/>
            <pc:sldMk cId="1105138256" sldId="259"/>
            <ac:picMk id="18" creationId="{E68E6BBC-D422-A289-C571-08AA0B34059C}"/>
          </ac:picMkLst>
        </pc:picChg>
        <pc:picChg chg="del mod">
          <ac:chgData name="濵田　大治" userId="3dc346c6-a235-4d96-b756-7f3e038a9511" providerId="ADAL" clId="{265472C0-0AD8-4F9D-9100-4602D5E3EE92}" dt="2023-04-04T07:56:58.736" v="195" actId="478"/>
          <ac:picMkLst>
            <pc:docMk/>
            <pc:sldMk cId="1105138256" sldId="259"/>
            <ac:picMk id="19" creationId="{FB6A593D-5E4D-B8F2-4DDA-E91B3456C14D}"/>
          </ac:picMkLst>
        </pc:picChg>
        <pc:picChg chg="del mod">
          <ac:chgData name="濵田　大治" userId="3dc346c6-a235-4d96-b756-7f3e038a9511" providerId="ADAL" clId="{265472C0-0AD8-4F9D-9100-4602D5E3EE92}" dt="2023-04-04T08:01:40.380" v="214" actId="478"/>
          <ac:picMkLst>
            <pc:docMk/>
            <pc:sldMk cId="1105138256" sldId="259"/>
            <ac:picMk id="27" creationId="{822D2D39-E451-1833-BAC0-89C3D26C890E}"/>
          </ac:picMkLst>
        </pc:picChg>
        <pc:picChg chg="del mod">
          <ac:chgData name="濵田　大治" userId="3dc346c6-a235-4d96-b756-7f3e038a9511" providerId="ADAL" clId="{265472C0-0AD8-4F9D-9100-4602D5E3EE92}" dt="2023-04-04T07:48:43.993" v="121" actId="478"/>
          <ac:picMkLst>
            <pc:docMk/>
            <pc:sldMk cId="1105138256" sldId="259"/>
            <ac:picMk id="28" creationId="{28452614-43A4-00E3-5CC8-0F1A183866F1}"/>
          </ac:picMkLst>
        </pc:picChg>
        <pc:picChg chg="add del mod modCrop">
          <ac:chgData name="濵田　大治" userId="3dc346c6-a235-4d96-b756-7f3e038a9511" providerId="ADAL" clId="{265472C0-0AD8-4F9D-9100-4602D5E3EE92}" dt="2023-04-04T07:56:00.145" v="184" actId="478"/>
          <ac:picMkLst>
            <pc:docMk/>
            <pc:sldMk cId="1105138256" sldId="259"/>
            <ac:picMk id="30" creationId="{06411B2F-0190-C7F8-2E53-7B89D2D8B014}"/>
          </ac:picMkLst>
        </pc:picChg>
        <pc:picChg chg="add mod ord">
          <ac:chgData name="濵田　大治" userId="3dc346c6-a235-4d96-b756-7f3e038a9511" providerId="ADAL" clId="{265472C0-0AD8-4F9D-9100-4602D5E3EE92}" dt="2023-04-04T07:57:16.437" v="197" actId="1076"/>
          <ac:picMkLst>
            <pc:docMk/>
            <pc:sldMk cId="1105138256" sldId="259"/>
            <ac:picMk id="31" creationId="{BBEDA544-0F08-5F4F-70E4-C0B033F299BE}"/>
          </ac:picMkLst>
        </pc:picChg>
        <pc:picChg chg="add del mod modCrop">
          <ac:chgData name="濵田　大治" userId="3dc346c6-a235-4d96-b756-7f3e038a9511" providerId="ADAL" clId="{265472C0-0AD8-4F9D-9100-4602D5E3EE92}" dt="2023-04-04T08:00:58.533" v="207" actId="478"/>
          <ac:picMkLst>
            <pc:docMk/>
            <pc:sldMk cId="1105138256" sldId="259"/>
            <ac:picMk id="33" creationId="{F33CDCD1-EBBE-8B29-54C0-D68C98B17E8E}"/>
          </ac:picMkLst>
        </pc:picChg>
        <pc:picChg chg="add mod ord">
          <ac:chgData name="濵田　大治" userId="3dc346c6-a235-4d96-b756-7f3e038a9511" providerId="ADAL" clId="{265472C0-0AD8-4F9D-9100-4602D5E3EE92}" dt="2023-04-04T08:02:01.104" v="221" actId="167"/>
          <ac:picMkLst>
            <pc:docMk/>
            <pc:sldMk cId="1105138256" sldId="259"/>
            <ac:picMk id="34" creationId="{5E23F586-7D40-9AFD-66E5-380D806FE0EF}"/>
          </ac:picMkLst>
        </pc:picChg>
      </pc:sldChg>
      <pc:sldChg chg="addSp delSp modSp mod">
        <pc:chgData name="濵田　大治" userId="3dc346c6-a235-4d96-b756-7f3e038a9511" providerId="ADAL" clId="{265472C0-0AD8-4F9D-9100-4602D5E3EE92}" dt="2023-04-04T07:53:46.231" v="172" actId="1076"/>
        <pc:sldMkLst>
          <pc:docMk/>
          <pc:sldMk cId="3665629369" sldId="260"/>
        </pc:sldMkLst>
        <pc:spChg chg="mod">
          <ac:chgData name="濵田　大治" userId="3dc346c6-a235-4d96-b756-7f3e038a9511" providerId="ADAL" clId="{265472C0-0AD8-4F9D-9100-4602D5E3EE92}" dt="2023-04-04T07:53:46.231" v="172" actId="1076"/>
          <ac:spMkLst>
            <pc:docMk/>
            <pc:sldMk cId="3665629369" sldId="260"/>
            <ac:spMk id="7" creationId="{50FEC825-AE2B-9FF0-CDEF-B99EA12E07A3}"/>
          </ac:spMkLst>
        </pc:spChg>
        <pc:spChg chg="mod">
          <ac:chgData name="濵田　大治" userId="3dc346c6-a235-4d96-b756-7f3e038a9511" providerId="ADAL" clId="{265472C0-0AD8-4F9D-9100-4602D5E3EE92}" dt="2023-04-04T07:53:46.231" v="172" actId="1076"/>
          <ac:spMkLst>
            <pc:docMk/>
            <pc:sldMk cId="3665629369" sldId="260"/>
            <ac:spMk id="8" creationId="{72C1DD76-8AA7-C565-242E-80107ED73F08}"/>
          </ac:spMkLst>
        </pc:spChg>
        <pc:spChg chg="mod">
          <ac:chgData name="濵田　大治" userId="3dc346c6-a235-4d96-b756-7f3e038a9511" providerId="ADAL" clId="{265472C0-0AD8-4F9D-9100-4602D5E3EE92}" dt="2023-04-04T07:52:40.510" v="154" actId="14100"/>
          <ac:spMkLst>
            <pc:docMk/>
            <pc:sldMk cId="3665629369" sldId="260"/>
            <ac:spMk id="9" creationId="{6931CF5D-B3F5-33DB-B16F-3BC0CB5577B0}"/>
          </ac:spMkLst>
        </pc:spChg>
        <pc:spChg chg="mod">
          <ac:chgData name="濵田　大治" userId="3dc346c6-a235-4d96-b756-7f3e038a9511" providerId="ADAL" clId="{265472C0-0AD8-4F9D-9100-4602D5E3EE92}" dt="2023-04-04T07:53:46.231" v="172" actId="1076"/>
          <ac:spMkLst>
            <pc:docMk/>
            <pc:sldMk cId="3665629369" sldId="260"/>
            <ac:spMk id="11" creationId="{9051B61D-22E5-63D0-3721-98A26783DD99}"/>
          </ac:spMkLst>
        </pc:spChg>
        <pc:spChg chg="del mod">
          <ac:chgData name="濵田　大治" userId="3dc346c6-a235-4d96-b756-7f3e038a9511" providerId="ADAL" clId="{265472C0-0AD8-4F9D-9100-4602D5E3EE92}" dt="2023-04-04T07:47:30.697" v="110" actId="478"/>
          <ac:spMkLst>
            <pc:docMk/>
            <pc:sldMk cId="3665629369" sldId="260"/>
            <ac:spMk id="13" creationId="{BA0ABD70-22B5-B75E-D56B-B690BF4721B0}"/>
          </ac:spMkLst>
        </pc:spChg>
        <pc:spChg chg="del mod">
          <ac:chgData name="濵田　大治" userId="3dc346c6-a235-4d96-b756-7f3e038a9511" providerId="ADAL" clId="{265472C0-0AD8-4F9D-9100-4602D5E3EE92}" dt="2023-04-04T07:47:30.697" v="110" actId="478"/>
          <ac:spMkLst>
            <pc:docMk/>
            <pc:sldMk cId="3665629369" sldId="260"/>
            <ac:spMk id="14" creationId="{4A9A80DD-9095-7AA4-9E18-B1D95432DA60}"/>
          </ac:spMkLst>
        </pc:spChg>
        <pc:spChg chg="del mod">
          <ac:chgData name="濵田　大治" userId="3dc346c6-a235-4d96-b756-7f3e038a9511" providerId="ADAL" clId="{265472C0-0AD8-4F9D-9100-4602D5E3EE92}" dt="2023-04-04T07:47:30.697" v="110" actId="478"/>
          <ac:spMkLst>
            <pc:docMk/>
            <pc:sldMk cId="3665629369" sldId="260"/>
            <ac:spMk id="15" creationId="{E9D7AD65-5FFD-25F0-19E5-82AF3EC11446}"/>
          </ac:spMkLst>
        </pc:spChg>
        <pc:spChg chg="del mod">
          <ac:chgData name="濵田　大治" userId="3dc346c6-a235-4d96-b756-7f3e038a9511" providerId="ADAL" clId="{265472C0-0AD8-4F9D-9100-4602D5E3EE92}" dt="2023-04-04T07:47:30.697" v="110" actId="478"/>
          <ac:spMkLst>
            <pc:docMk/>
            <pc:sldMk cId="3665629369" sldId="260"/>
            <ac:spMk id="16" creationId="{2C205221-A575-4568-653F-0D3E16861442}"/>
          </ac:spMkLst>
        </pc:spChg>
        <pc:spChg chg="del mod">
          <ac:chgData name="濵田　大治" userId="3dc346c6-a235-4d96-b756-7f3e038a9511" providerId="ADAL" clId="{265472C0-0AD8-4F9D-9100-4602D5E3EE92}" dt="2023-04-04T07:45:50.164" v="91" actId="478"/>
          <ac:spMkLst>
            <pc:docMk/>
            <pc:sldMk cId="3665629369" sldId="260"/>
            <ac:spMk id="18" creationId="{A6C7E8E1-8C0D-084F-D73A-5CEE0C75ED24}"/>
          </ac:spMkLst>
        </pc:spChg>
        <pc:spChg chg="add mod">
          <ac:chgData name="濵田　大治" userId="3dc346c6-a235-4d96-b756-7f3e038a9511" providerId="ADAL" clId="{265472C0-0AD8-4F9D-9100-4602D5E3EE92}" dt="2023-04-04T07:53:46.231" v="172" actId="1076"/>
          <ac:spMkLst>
            <pc:docMk/>
            <pc:sldMk cId="3665629369" sldId="260"/>
            <ac:spMk id="24" creationId="{F113F0DF-0DFD-B56B-64A6-04E349653166}"/>
          </ac:spMkLst>
        </pc:spChg>
        <pc:spChg chg="mod">
          <ac:chgData name="濵田　大治" userId="3dc346c6-a235-4d96-b756-7f3e038a9511" providerId="ADAL" clId="{265472C0-0AD8-4F9D-9100-4602D5E3EE92}" dt="2023-04-04T07:53:41.052" v="171" actId="1076"/>
          <ac:spMkLst>
            <pc:docMk/>
            <pc:sldMk cId="3665629369" sldId="260"/>
            <ac:spMk id="35" creationId="{5033288D-B78F-9204-BC70-14DB80BAEAE2}"/>
          </ac:spMkLst>
        </pc:spChg>
        <pc:spChg chg="del mod">
          <ac:chgData name="濵田　大治" userId="3dc346c6-a235-4d96-b756-7f3e038a9511" providerId="ADAL" clId="{265472C0-0AD8-4F9D-9100-4602D5E3EE92}" dt="2023-04-04T07:47:30.697" v="110" actId="478"/>
          <ac:spMkLst>
            <pc:docMk/>
            <pc:sldMk cId="3665629369" sldId="260"/>
            <ac:spMk id="36" creationId="{3BF1628E-2D2C-99B9-2AFE-C5D51E1640AA}"/>
          </ac:spMkLst>
        </pc:spChg>
        <pc:picChg chg="del mod">
          <ac:chgData name="濵田　大治" userId="3dc346c6-a235-4d96-b756-7f3e038a9511" providerId="ADAL" clId="{265472C0-0AD8-4F9D-9100-4602D5E3EE92}" dt="2023-04-04T07:46:00.215" v="94" actId="478"/>
          <ac:picMkLst>
            <pc:docMk/>
            <pc:sldMk cId="3665629369" sldId="260"/>
            <ac:picMk id="2" creationId="{C6123797-6AFE-07C9-3244-082DB32D98E4}"/>
          </ac:picMkLst>
        </pc:picChg>
        <pc:picChg chg="del mod">
          <ac:chgData name="濵田　大治" userId="3dc346c6-a235-4d96-b756-7f3e038a9511" providerId="ADAL" clId="{265472C0-0AD8-4F9D-9100-4602D5E3EE92}" dt="2023-04-04T07:45:59.660" v="93" actId="478"/>
          <ac:picMkLst>
            <pc:docMk/>
            <pc:sldMk cId="3665629369" sldId="260"/>
            <ac:picMk id="4" creationId="{567C3B01-1DC2-4D9F-1E61-106A0B6ECAA4}"/>
          </ac:picMkLst>
        </pc:picChg>
        <pc:picChg chg="add del mod modCrop">
          <ac:chgData name="濵田　大治" userId="3dc346c6-a235-4d96-b756-7f3e038a9511" providerId="ADAL" clId="{265472C0-0AD8-4F9D-9100-4602D5E3EE92}" dt="2023-04-04T07:27:47.744" v="15" actId="478"/>
          <ac:picMkLst>
            <pc:docMk/>
            <pc:sldMk cId="3665629369" sldId="260"/>
            <ac:picMk id="5" creationId="{F2326FE4-48BE-7BD7-14D2-18BA83654296}"/>
          </ac:picMkLst>
        </pc:picChg>
        <pc:picChg chg="add mod ord">
          <ac:chgData name="濵田　大治" userId="3dc346c6-a235-4d96-b756-7f3e038a9511" providerId="ADAL" clId="{265472C0-0AD8-4F9D-9100-4602D5E3EE92}" dt="2023-04-04T07:53:46.231" v="172" actId="1076"/>
          <ac:picMkLst>
            <pc:docMk/>
            <pc:sldMk cId="3665629369" sldId="260"/>
            <ac:picMk id="10" creationId="{50438A98-F679-D9B8-EF7C-9DC7C1778F88}"/>
          </ac:picMkLst>
        </pc:picChg>
        <pc:picChg chg="del mod">
          <ac:chgData name="濵田　大治" userId="3dc346c6-a235-4d96-b756-7f3e038a9511" providerId="ADAL" clId="{265472C0-0AD8-4F9D-9100-4602D5E3EE92}" dt="2023-04-04T07:45:59.024" v="92" actId="478"/>
          <ac:picMkLst>
            <pc:docMk/>
            <pc:sldMk cId="3665629369" sldId="260"/>
            <ac:picMk id="12" creationId="{563871BA-8A1F-7A72-5435-808700CFA0D3}"/>
          </ac:picMkLst>
        </pc:picChg>
        <pc:picChg chg="add del mod modCrop">
          <ac:chgData name="濵田　大治" userId="3dc346c6-a235-4d96-b756-7f3e038a9511" providerId="ADAL" clId="{265472C0-0AD8-4F9D-9100-4602D5E3EE92}" dt="2023-04-04T07:31:19.982" v="27" actId="478"/>
          <ac:picMkLst>
            <pc:docMk/>
            <pc:sldMk cId="3665629369" sldId="260"/>
            <ac:picMk id="19" creationId="{20F9E720-0D77-FF6A-86E0-693755F1CD74}"/>
          </ac:picMkLst>
        </pc:picChg>
        <pc:picChg chg="add mod ord">
          <ac:chgData name="濵田　大治" userId="3dc346c6-a235-4d96-b756-7f3e038a9511" providerId="ADAL" clId="{265472C0-0AD8-4F9D-9100-4602D5E3EE92}" dt="2023-04-04T07:52:40.510" v="154" actId="14100"/>
          <ac:picMkLst>
            <pc:docMk/>
            <pc:sldMk cId="3665629369" sldId="260"/>
            <ac:picMk id="20" creationId="{756C7660-A698-B2DB-35D9-C200087B6107}"/>
          </ac:picMkLst>
        </pc:picChg>
        <pc:picChg chg="add del mod modCrop">
          <ac:chgData name="濵田　大治" userId="3dc346c6-a235-4d96-b756-7f3e038a9511" providerId="ADAL" clId="{265472C0-0AD8-4F9D-9100-4602D5E3EE92}" dt="2023-04-04T07:33:09.613" v="41" actId="478"/>
          <ac:picMkLst>
            <pc:docMk/>
            <pc:sldMk cId="3665629369" sldId="260"/>
            <ac:picMk id="22" creationId="{5B8269BD-F565-8696-7D96-CCE5FF52681A}"/>
          </ac:picMkLst>
        </pc:picChg>
        <pc:picChg chg="add mod ord">
          <ac:chgData name="濵田　大治" userId="3dc346c6-a235-4d96-b756-7f3e038a9511" providerId="ADAL" clId="{265472C0-0AD8-4F9D-9100-4602D5E3EE92}" dt="2023-04-04T07:53:46.231" v="172" actId="1076"/>
          <ac:picMkLst>
            <pc:docMk/>
            <pc:sldMk cId="3665629369" sldId="260"/>
            <ac:picMk id="23" creationId="{99A34FB2-2690-756C-3FFF-5B24B616FE1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40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1429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775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5768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8667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5523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683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8223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3324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0470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3555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2380B-4C6C-4EDF-AE83-875CD1A3B2E6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BA866-74EC-4ECD-BF52-6D273623E2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0335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 descr="スクリーンショットの画面&#10;&#10;自動的に生成された説明">
            <a:extLst>
              <a:ext uri="{FF2B5EF4-FFF2-40B4-BE49-F238E27FC236}">
                <a16:creationId xmlns:a16="http://schemas.microsoft.com/office/drawing/2014/main" id="{8DD24D82-2677-54AA-C424-71056340B4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0409" y="1712698"/>
            <a:ext cx="3038856" cy="1688592"/>
          </a:xfrm>
          <a:prstGeom prst="rect">
            <a:avLst/>
          </a:prstGeom>
        </p:spPr>
      </p:pic>
      <p:pic>
        <p:nvPicPr>
          <p:cNvPr id="2" name="図 1" descr="座る, 鳥, テーブル, グループ が含まれている画像&#10;&#10;自動的に生成された説明">
            <a:extLst>
              <a:ext uri="{FF2B5EF4-FFF2-40B4-BE49-F238E27FC236}">
                <a16:creationId xmlns:a16="http://schemas.microsoft.com/office/drawing/2014/main" id="{E1C4239A-1D9A-7CF4-66B7-BC2BE5C49E0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0409" y="3815879"/>
            <a:ext cx="3038856" cy="1688592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8D8ADA3-D8E1-D1E5-3260-4C17F8980780}"/>
              </a:ext>
            </a:extLst>
          </p:cNvPr>
          <p:cNvSpPr/>
          <p:nvPr/>
        </p:nvSpPr>
        <p:spPr>
          <a:xfrm>
            <a:off x="2300275" y="2018733"/>
            <a:ext cx="1296000" cy="288000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4A764C2-6899-6F81-58EC-62FE6233A1EA}"/>
              </a:ext>
            </a:extLst>
          </p:cNvPr>
          <p:cNvSpPr/>
          <p:nvPr/>
        </p:nvSpPr>
        <p:spPr>
          <a:xfrm>
            <a:off x="2300005" y="4917309"/>
            <a:ext cx="1296000" cy="288000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9E893D0-3FCA-97F7-A79B-508862C96441}"/>
              </a:ext>
            </a:extLst>
          </p:cNvPr>
          <p:cNvSpPr txBox="1"/>
          <p:nvPr/>
        </p:nvSpPr>
        <p:spPr>
          <a:xfrm>
            <a:off x="709750" y="528302"/>
            <a:ext cx="3859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blots related to Figure 1C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0FEC825-AE2B-9FF0-CDEF-B99EA12E07A3}"/>
              </a:ext>
            </a:extLst>
          </p:cNvPr>
          <p:cNvSpPr txBox="1"/>
          <p:nvPr/>
        </p:nvSpPr>
        <p:spPr>
          <a:xfrm>
            <a:off x="2020409" y="1404921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1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2C1DD76-8AA7-C565-242E-80107ED73F08}"/>
              </a:ext>
            </a:extLst>
          </p:cNvPr>
          <p:cNvSpPr txBox="1"/>
          <p:nvPr/>
        </p:nvSpPr>
        <p:spPr>
          <a:xfrm>
            <a:off x="2020409" y="3508102"/>
            <a:ext cx="7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A0ABD70-22B5-B75E-D56B-B690BF4721B0}"/>
              </a:ext>
            </a:extLst>
          </p:cNvPr>
          <p:cNvSpPr txBox="1"/>
          <p:nvPr/>
        </p:nvSpPr>
        <p:spPr>
          <a:xfrm>
            <a:off x="1709578" y="1897036"/>
            <a:ext cx="450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A9A80DD-9095-7AA4-9E18-B1D95432DA60}"/>
              </a:ext>
            </a:extLst>
          </p:cNvPr>
          <p:cNvSpPr txBox="1"/>
          <p:nvPr/>
        </p:nvSpPr>
        <p:spPr>
          <a:xfrm>
            <a:off x="1709578" y="2027343"/>
            <a:ext cx="450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 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9D7AD65-5FFD-25F0-19E5-82AF3EC11446}"/>
              </a:ext>
            </a:extLst>
          </p:cNvPr>
          <p:cNvSpPr txBox="1"/>
          <p:nvPr/>
        </p:nvSpPr>
        <p:spPr>
          <a:xfrm>
            <a:off x="1711119" y="2166577"/>
            <a:ext cx="4507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C205221-A575-4568-653F-0D3E16861442}"/>
              </a:ext>
            </a:extLst>
          </p:cNvPr>
          <p:cNvSpPr txBox="1"/>
          <p:nvPr/>
        </p:nvSpPr>
        <p:spPr>
          <a:xfrm>
            <a:off x="1767151" y="4888337"/>
            <a:ext cx="3930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 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 descr="水, テーブル, 座る, ガラス が含まれている画像&#10;&#10;自動的に生成された説明">
            <a:extLst>
              <a:ext uri="{FF2B5EF4-FFF2-40B4-BE49-F238E27FC236}">
                <a16:creationId xmlns:a16="http://schemas.microsoft.com/office/drawing/2014/main" id="{1EEA46C0-DB32-C91C-52B7-B7225D7203D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2383" y="1712697"/>
            <a:ext cx="3038857" cy="1688593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83146D1-D8EE-7B79-320D-3015D9CFD045}"/>
              </a:ext>
            </a:extLst>
          </p:cNvPr>
          <p:cNvSpPr txBox="1"/>
          <p:nvPr/>
        </p:nvSpPr>
        <p:spPr>
          <a:xfrm>
            <a:off x="5642383" y="1404920"/>
            <a:ext cx="18276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1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ong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)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6321D6E9-BCDF-DC2B-CD41-71CF214BA139}"/>
              </a:ext>
            </a:extLst>
          </p:cNvPr>
          <p:cNvCxnSpPr>
            <a:cxnSpLocks/>
          </p:cNvCxnSpPr>
          <p:nvPr/>
        </p:nvCxnSpPr>
        <p:spPr>
          <a:xfrm flipV="1">
            <a:off x="5743699" y="3374505"/>
            <a:ext cx="0" cy="216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3D83306-CBA2-7A82-DD33-75BED68CAD04}"/>
              </a:ext>
            </a:extLst>
          </p:cNvPr>
          <p:cNvSpPr txBox="1"/>
          <p:nvPr/>
        </p:nvSpPr>
        <p:spPr>
          <a:xfrm>
            <a:off x="5312523" y="3590505"/>
            <a:ext cx="13276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ge of membrane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25460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3F5B7AC-381B-B460-6FE9-C1B04610D5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2529" y="1283423"/>
            <a:ext cx="3060942" cy="2770398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E2C39667-D693-4D27-7821-EF92324630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9946" y="4440812"/>
            <a:ext cx="5686107" cy="197494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9E893D0-3FCA-97F7-A79B-508862C96441}"/>
              </a:ext>
            </a:extLst>
          </p:cNvPr>
          <p:cNvSpPr txBox="1"/>
          <p:nvPr/>
        </p:nvSpPr>
        <p:spPr>
          <a:xfrm>
            <a:off x="709750" y="528302"/>
            <a:ext cx="3859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blots related to Figure 2C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0FEC825-AE2B-9FF0-CDEF-B99EA12E07A3}"/>
              </a:ext>
            </a:extLst>
          </p:cNvPr>
          <p:cNvSpPr txBox="1"/>
          <p:nvPr/>
        </p:nvSpPr>
        <p:spPr>
          <a:xfrm>
            <a:off x="3422529" y="974443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1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2C1DD76-8AA7-C565-242E-80107ED73F08}"/>
              </a:ext>
            </a:extLst>
          </p:cNvPr>
          <p:cNvSpPr txBox="1"/>
          <p:nvPr/>
        </p:nvSpPr>
        <p:spPr>
          <a:xfrm>
            <a:off x="2109946" y="4130630"/>
            <a:ext cx="7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E6EF5794-ACD2-1C54-4CDC-2C60CAA6E053}"/>
              </a:ext>
            </a:extLst>
          </p:cNvPr>
          <p:cNvSpPr/>
          <p:nvPr/>
        </p:nvSpPr>
        <p:spPr>
          <a:xfrm>
            <a:off x="4090516" y="2264537"/>
            <a:ext cx="1979221" cy="454285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F2904211-4805-885F-5465-CC578AFAF2A2}"/>
              </a:ext>
            </a:extLst>
          </p:cNvPr>
          <p:cNvSpPr/>
          <p:nvPr/>
        </p:nvSpPr>
        <p:spPr>
          <a:xfrm>
            <a:off x="2557006" y="5194738"/>
            <a:ext cx="1943840" cy="32167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2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図 33">
            <a:extLst>
              <a:ext uri="{FF2B5EF4-FFF2-40B4-BE49-F238E27FC236}">
                <a16:creationId xmlns:a16="http://schemas.microsoft.com/office/drawing/2014/main" id="{5E23F586-7D40-9AFD-66E5-380D806FE0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20948" y="571396"/>
            <a:ext cx="2619539" cy="3506558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BBEDA544-0F08-5F4F-70E4-C0B033F299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1467" y="1744249"/>
            <a:ext cx="3941967" cy="1494381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E68E6BBC-D422-A289-C571-08AA0B3405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1467" y="4079098"/>
            <a:ext cx="3941967" cy="1855043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1D04D21-0EFA-DA55-8E67-1788AC5390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59735" y="4470350"/>
            <a:ext cx="3941967" cy="221433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9E893D0-3FCA-97F7-A79B-508862C96441}"/>
              </a:ext>
            </a:extLst>
          </p:cNvPr>
          <p:cNvSpPr txBox="1"/>
          <p:nvPr/>
        </p:nvSpPr>
        <p:spPr>
          <a:xfrm>
            <a:off x="709750" y="528302"/>
            <a:ext cx="3859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blots related to Figure 6C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0FEC825-AE2B-9FF0-CDEF-B99EA12E07A3}"/>
              </a:ext>
            </a:extLst>
          </p:cNvPr>
          <p:cNvSpPr txBox="1"/>
          <p:nvPr/>
        </p:nvSpPr>
        <p:spPr>
          <a:xfrm>
            <a:off x="991467" y="1435900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1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2C1DD76-8AA7-C565-242E-80107ED73F08}"/>
              </a:ext>
            </a:extLst>
          </p:cNvPr>
          <p:cNvSpPr txBox="1"/>
          <p:nvPr/>
        </p:nvSpPr>
        <p:spPr>
          <a:xfrm>
            <a:off x="991467" y="3770177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FU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5E4A5850-5FB8-976F-2978-B81D21F57590}"/>
              </a:ext>
            </a:extLst>
          </p:cNvPr>
          <p:cNvSpPr/>
          <p:nvPr/>
        </p:nvSpPr>
        <p:spPr>
          <a:xfrm>
            <a:off x="6466195" y="1242201"/>
            <a:ext cx="1590970" cy="454285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AC04AF93-84B7-9D73-6456-9C61CAA2754D}"/>
              </a:ext>
            </a:extLst>
          </p:cNvPr>
          <p:cNvSpPr/>
          <p:nvPr/>
        </p:nvSpPr>
        <p:spPr>
          <a:xfrm>
            <a:off x="7180613" y="5453610"/>
            <a:ext cx="1452748" cy="365824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4FBE997-F336-A1C5-AA12-735F9BF4D912}"/>
              </a:ext>
            </a:extLst>
          </p:cNvPr>
          <p:cNvSpPr/>
          <p:nvPr/>
        </p:nvSpPr>
        <p:spPr>
          <a:xfrm>
            <a:off x="1436914" y="4327479"/>
            <a:ext cx="1328276" cy="368492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4A5B56C5-2831-F674-6EE3-8029B573544C}"/>
              </a:ext>
            </a:extLst>
          </p:cNvPr>
          <p:cNvSpPr/>
          <p:nvPr/>
        </p:nvSpPr>
        <p:spPr>
          <a:xfrm>
            <a:off x="1596120" y="2214616"/>
            <a:ext cx="1288336" cy="324874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C622EB2-32BD-3C12-27B5-FE55471910AF}"/>
              </a:ext>
            </a:extLst>
          </p:cNvPr>
          <p:cNvSpPr txBox="1"/>
          <p:nvPr/>
        </p:nvSpPr>
        <p:spPr>
          <a:xfrm>
            <a:off x="5712478" y="263619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1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CCD35AA-7E5B-2D32-DFE5-1DC139F2DE18}"/>
              </a:ext>
            </a:extLst>
          </p:cNvPr>
          <p:cNvSpPr txBox="1"/>
          <p:nvPr/>
        </p:nvSpPr>
        <p:spPr>
          <a:xfrm>
            <a:off x="5059735" y="4149080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FU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51382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50438A98-F679-D9B8-EF7C-9DC7C1778F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3822" y="1680203"/>
            <a:ext cx="4224894" cy="2347163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756C7660-A698-B2DB-35D9-C200087B61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0" y="4162399"/>
            <a:ext cx="4225175" cy="1939636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99A34FB2-2690-756C-3FFF-5B24B616FE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53000" y="1680203"/>
            <a:ext cx="4225175" cy="199747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9E893D0-3FCA-97F7-A79B-508862C96441}"/>
              </a:ext>
            </a:extLst>
          </p:cNvPr>
          <p:cNvSpPr txBox="1"/>
          <p:nvPr/>
        </p:nvSpPr>
        <p:spPr>
          <a:xfrm>
            <a:off x="709750" y="528302"/>
            <a:ext cx="3859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blots related to Figure 7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0FEC825-AE2B-9FF0-CDEF-B99EA12E07A3}"/>
              </a:ext>
            </a:extLst>
          </p:cNvPr>
          <p:cNvSpPr txBox="1"/>
          <p:nvPr/>
        </p:nvSpPr>
        <p:spPr>
          <a:xfrm>
            <a:off x="603822" y="1372425"/>
            <a:ext cx="822661" cy="307777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ag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2C1DD76-8AA7-C565-242E-80107ED73F08}"/>
              </a:ext>
            </a:extLst>
          </p:cNvPr>
          <p:cNvSpPr txBox="1"/>
          <p:nvPr/>
        </p:nvSpPr>
        <p:spPr>
          <a:xfrm>
            <a:off x="4953000" y="1372426"/>
            <a:ext cx="803425" cy="307777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AC1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6931CF5D-B3F5-33DB-B16F-3BC0CB5577B0}"/>
              </a:ext>
            </a:extLst>
          </p:cNvPr>
          <p:cNvSpPr/>
          <p:nvPr/>
        </p:nvSpPr>
        <p:spPr>
          <a:xfrm>
            <a:off x="7178065" y="4819752"/>
            <a:ext cx="1571663" cy="358045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9051B61D-22E5-63D0-3721-98A26783DD99}"/>
              </a:ext>
            </a:extLst>
          </p:cNvPr>
          <p:cNvSpPr/>
          <p:nvPr/>
        </p:nvSpPr>
        <p:spPr>
          <a:xfrm>
            <a:off x="7178065" y="2147270"/>
            <a:ext cx="1666665" cy="369647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033288D-B78F-9204-BC70-14DB80BAEAE2}"/>
              </a:ext>
            </a:extLst>
          </p:cNvPr>
          <p:cNvSpPr txBox="1"/>
          <p:nvPr/>
        </p:nvSpPr>
        <p:spPr>
          <a:xfrm>
            <a:off x="4953000" y="3854622"/>
            <a:ext cx="704039" cy="307777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K1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F113F0DF-0DFD-B56B-64A6-04E349653166}"/>
              </a:ext>
            </a:extLst>
          </p:cNvPr>
          <p:cNvSpPr/>
          <p:nvPr/>
        </p:nvSpPr>
        <p:spPr>
          <a:xfrm>
            <a:off x="1106846" y="2699309"/>
            <a:ext cx="1569950" cy="405622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5629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4</TotalTime>
  <Words>53</Words>
  <Application>Microsoft Office PowerPoint</Application>
  <PresentationFormat>A4 210 x 297 mm</PresentationFormat>
  <Paragraphs>21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濵田　大治</dc:creator>
  <cp:lastModifiedBy>濵田　大治</cp:lastModifiedBy>
  <cp:revision>1</cp:revision>
  <dcterms:created xsi:type="dcterms:W3CDTF">2023-01-31T04:37:02Z</dcterms:created>
  <dcterms:modified xsi:type="dcterms:W3CDTF">2023-04-04T09:19:14Z</dcterms:modified>
</cp:coreProperties>
</file>